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  <a:srgbClr val="FF00FF"/>
    <a:srgbClr val="69F3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76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68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910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2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623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0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46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729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008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147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518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703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video" Target="NULL" TargetMode="External"/><Relationship Id="rId7" Type="http://schemas.openxmlformats.org/officeDocument/2006/relationships/image" Target="../media/image4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7.xml"/><Relationship Id="rId4" Type="http://schemas.microsoft.com/office/2007/relationships/media" Target="../media/media2.avi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061385" y="1311895"/>
            <a:ext cx="102108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Palatino Linotype" panose="02040502050505030304" pitchFamily="18" charset="0"/>
              </a:rPr>
              <a:t>Identifying the Morphological and Molecular Features of a Cell-Based </a:t>
            </a:r>
            <a:r>
              <a:rPr lang="en-US" sz="2000" b="1" dirty="0" err="1">
                <a:latin typeface="Palatino Linotype" panose="02040502050505030304" pitchFamily="18" charset="0"/>
              </a:rPr>
              <a:t>Orthotopic</a:t>
            </a:r>
            <a:r>
              <a:rPr lang="en-US" sz="2000" b="1" dirty="0">
                <a:latin typeface="Palatino Linotype" panose="02040502050505030304" pitchFamily="18" charset="0"/>
              </a:rPr>
              <a:t> Pancreatic Cancer Mouse Model during Growth over Time</a:t>
            </a:r>
            <a:r>
              <a:rPr lang="en-US" sz="2000" b="1" dirty="0" smtClean="0">
                <a:latin typeface="Palatino Linotype" panose="02040502050505030304" pitchFamily="18" charset="0"/>
              </a:rPr>
              <a:t>.</a:t>
            </a:r>
            <a:endParaRPr lang="de-DE" sz="2000" b="1" dirty="0">
              <a:latin typeface="Palatino Linotype" panose="02040502050505030304" pitchFamily="18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2247900" y="2289662"/>
            <a:ext cx="7924800" cy="259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300"/>
              </a:lnSpc>
              <a:spcAft>
                <a:spcPts val="1800"/>
              </a:spcAft>
            </a:pPr>
            <a:r>
              <a:rPr lang="de-DE" sz="14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Felista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 L. Tansi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1*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Andrea Schrepp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Michael Schwarz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Ulf Teichgräb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3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Ingrid Hilg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1*</a:t>
            </a:r>
            <a:endParaRPr lang="de-DE" sz="1400" b="1" dirty="0">
              <a:solidFill>
                <a:srgbClr val="000000"/>
              </a:solidFill>
              <a:latin typeface="Palatino Linotype" panose="02040502050505030304" pitchFamily="18" charset="0"/>
              <a:ea typeface="Times New Roman"/>
              <a:cs typeface="Times New Roman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981200" y="2729300"/>
            <a:ext cx="8458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1</a:t>
            </a:r>
            <a:r>
              <a:rPr lang="de-DE" sz="1200" dirty="0">
                <a:latin typeface="Palatino Linotype" panose="02040502050505030304" pitchFamily="18" charset="0"/>
              </a:rPr>
              <a:t>Institute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Diagnost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Interventional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, Experimental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 Group, Jena University Hospital, Jena - Friedrich Schiller University Jena, Am Klinikum 1, 07747 Jena, Germany.</a:t>
            </a:r>
          </a:p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2</a:t>
            </a:r>
            <a:r>
              <a:rPr lang="de-DE" sz="1200" dirty="0">
                <a:latin typeface="Palatino Linotype" panose="02040502050505030304" pitchFamily="18" charset="0"/>
              </a:rPr>
              <a:t>Department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Cardiothorac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Surgery</a:t>
            </a:r>
            <a:r>
              <a:rPr lang="de-DE" sz="12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3</a:t>
            </a:r>
            <a:r>
              <a:rPr lang="de-DE" sz="1200" dirty="0">
                <a:latin typeface="Palatino Linotype" panose="02040502050505030304" pitchFamily="18" charset="0"/>
              </a:rPr>
              <a:t>Institute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Diagnost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Interventional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</p:txBody>
      </p:sp>
      <p:sp>
        <p:nvSpPr>
          <p:cNvPr id="11" name="Rechteck 10"/>
          <p:cNvSpPr/>
          <p:nvPr/>
        </p:nvSpPr>
        <p:spPr>
          <a:xfrm>
            <a:off x="3124200" y="4214336"/>
            <a:ext cx="61722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400" smtClean="0">
                <a:latin typeface="Palatino Linotype" panose="02040502050505030304" pitchFamily="18" charset="0"/>
              </a:rPr>
              <a:t>*Correspondence</a:t>
            </a:r>
            <a:r>
              <a:rPr lang="de-DE" sz="1400" dirty="0">
                <a:latin typeface="Palatino Linotype" panose="02040502050505030304" pitchFamily="18" charset="0"/>
              </a:rPr>
              <a:t>: 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felista.tansi@med.uni-jena.de; Tel. +49-3641-9324993 (F.L.T.)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ingrid.hilger@med.uni-jena.de; Tel. +49-3641-9325921 (I.H.)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4678470" y="5638800"/>
            <a:ext cx="3063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video</a:t>
            </a:r>
            <a:r>
              <a:rPr lang="de-DE" sz="2000" b="1" dirty="0">
                <a:latin typeface="Palatino Linotype" panose="02040502050505030304" pitchFamily="18" charset="0"/>
              </a:rPr>
              <a:t> S1</a:t>
            </a: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7288421"/>
              </p:ext>
            </p:extLst>
          </p:nvPr>
        </p:nvGraphicFramePr>
        <p:xfrm>
          <a:off x="1061385" y="331276"/>
          <a:ext cx="7418832" cy="435610"/>
        </p:xfrm>
        <a:graphic>
          <a:graphicData uri="http://schemas.openxmlformats.org/drawingml/2006/table">
            <a:tbl>
              <a:tblPr firstRow="1" firstCol="1" bandRow="1"/>
              <a:tblGrid>
                <a:gridCol w="2602640">
                  <a:extLst>
                    <a:ext uri="{9D8B030D-6E8A-4147-A177-3AD203B41FA5}">
                      <a16:colId xmlns:a16="http://schemas.microsoft.com/office/drawing/2014/main" val="3085198136"/>
                    </a:ext>
                  </a:extLst>
                </a:gridCol>
                <a:gridCol w="3208201">
                  <a:extLst>
                    <a:ext uri="{9D8B030D-6E8A-4147-A177-3AD203B41FA5}">
                      <a16:colId xmlns:a16="http://schemas.microsoft.com/office/drawing/2014/main" val="802794709"/>
                    </a:ext>
                  </a:extLst>
                </a:gridCol>
                <a:gridCol w="1607991">
                  <a:extLst>
                    <a:ext uri="{9D8B030D-6E8A-4147-A177-3AD203B41FA5}">
                      <a16:colId xmlns:a16="http://schemas.microsoft.com/office/drawing/2014/main" val="623146093"/>
                    </a:ext>
                  </a:extLst>
                </a:gridCol>
              </a:tblGrid>
              <a:tr h="43561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  <a:tabLst>
                          <a:tab pos="2637155" algn="ctr"/>
                          <a:tab pos="5274310" algn="r"/>
                        </a:tabLst>
                      </a:pPr>
                      <a:endParaRPr lang="de-DE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  <a:tabLst>
                          <a:tab pos="2637155" algn="ctr"/>
                          <a:tab pos="5274310" algn="r"/>
                        </a:tabLs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DengXian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200"/>
                        </a:lnSpc>
                        <a:spcAft>
                          <a:spcPts val="0"/>
                        </a:spcAft>
                        <a:tabLst>
                          <a:tab pos="2637155" algn="ctr"/>
                          <a:tab pos="5274310" algn="r"/>
                        </a:tabLst>
                      </a:pP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309672"/>
                  </a:ext>
                </a:extLst>
              </a:tr>
            </a:tbl>
          </a:graphicData>
        </a:graphic>
      </p:graphicFrame>
      <p:grpSp>
        <p:nvGrpSpPr>
          <p:cNvPr id="5" name="Gruppieren 4"/>
          <p:cNvGrpSpPr/>
          <p:nvPr/>
        </p:nvGrpSpPr>
        <p:grpSpPr>
          <a:xfrm>
            <a:off x="1062021" y="330800"/>
            <a:ext cx="10006617" cy="438150"/>
            <a:chOff x="1062021" y="330800"/>
            <a:chExt cx="10006617" cy="438150"/>
          </a:xfrm>
        </p:grpSpPr>
        <p:pic>
          <p:nvPicPr>
            <p:cNvPr id="1028" name="Picture 3" descr="ijms_logo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2" name="Rechteck 11"/>
          <p:cNvSpPr/>
          <p:nvPr/>
        </p:nvSpPr>
        <p:spPr>
          <a:xfrm>
            <a:off x="1654098" y="1058715"/>
            <a:ext cx="2529860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/>
            <a:r>
              <a:rPr lang="en-US" sz="1200" i="1" dirty="0">
                <a:latin typeface="Palatino Linotype" panose="02040502050505030304" pitchFamily="18" charset="0"/>
              </a:rPr>
              <a:t>Article, </a:t>
            </a:r>
            <a:r>
              <a:rPr lang="en-US" sz="1200" i="1" dirty="0">
                <a:solidFill>
                  <a:prstClr val="black"/>
                </a:solidFill>
                <a:latin typeface="Palatino Linotype" panose="02040502050505030304" pitchFamily="18" charset="0"/>
              </a:rPr>
              <a:t>supplementary video material</a:t>
            </a:r>
            <a:endParaRPr lang="de-DE" sz="1200" i="1" dirty="0">
              <a:solidFill>
                <a:prstClr val="black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5252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230514" y="4757708"/>
            <a:ext cx="775727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Video 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1: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Representativ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smtClean="0">
                <a:latin typeface="Palatino Linotype" panose="02040502050505030304" pitchFamily="18" charset="0"/>
                <a:cs typeface="Arial" panose="020B0604020202020204" pitchFamily="34" charset="0"/>
              </a:rPr>
              <a:t>cin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oop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ideo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cquir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in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id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position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a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mous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n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mental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infiltration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(A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) Video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in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si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emonstrating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l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asculariz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uodenum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(B) Video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id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si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howing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plee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kidney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mag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t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11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st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nduc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Note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ery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large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ar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Tu)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at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ppear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neat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plee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extend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oward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kidney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aecum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t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end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B.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h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iz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e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was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duc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on Handbrake-1.4.2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oftwar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endParaRPr lang="de-DE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(Li), Duodenum (D), Spleen (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p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),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Kidney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Ki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),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(St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, Tumor (Tu)</a:t>
            </a:r>
            <a:endParaRPr lang="en-US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6162831" y="988554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1600200" y="98855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3805249" y="438141"/>
            <a:ext cx="30636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video</a:t>
            </a:r>
            <a:r>
              <a:rPr lang="de-DE" sz="2000" b="1" dirty="0">
                <a:latin typeface="Palatino Linotype" panose="02040502050505030304" pitchFamily="18" charset="0"/>
              </a:rPr>
              <a:t> S1</a:t>
            </a:r>
          </a:p>
        </p:txBody>
      </p:sp>
      <p:pic>
        <p:nvPicPr>
          <p:cNvPr id="2" name="M4306 Wk11_2019-11-13-10-53-37-734_1 (video-converter.com)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t="10258"/>
          <a:stretch/>
        </p:blipFill>
        <p:spPr>
          <a:xfrm>
            <a:off x="2027724" y="958061"/>
            <a:ext cx="3486248" cy="3608986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4209003" y="264157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St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2889415" y="309522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40" name="Gerade Verbindung mit Pfeil 39"/>
          <p:cNvCxnSpPr/>
          <p:nvPr/>
        </p:nvCxnSpPr>
        <p:spPr>
          <a:xfrm flipH="1" flipV="1">
            <a:off x="2888813" y="2790429"/>
            <a:ext cx="153034" cy="304800"/>
          </a:xfrm>
          <a:prstGeom prst="straightConnector1">
            <a:avLst/>
          </a:prstGeom>
          <a:ln w="28575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3077928" y="2177941"/>
            <a:ext cx="401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Li</a:t>
            </a:r>
          </a:p>
        </p:txBody>
      </p:sp>
      <p:pic>
        <p:nvPicPr>
          <p:cNvPr id="3" name="M4306 Wk11_2019-11-13-10-59-03-906_1 (video-converter.com).avi">
            <a:hlinkClick r:id="" action="ppaction://media"/>
          </p:cNvPr>
          <p:cNvPicPr>
            <a:picLocks noChangeAspect="1"/>
          </p:cNvPicPr>
          <p:nvPr>
            <a:videoFile r:link="rId3"/>
            <p:extLst>
              <p:ext uri="{DAA4B4D4-6D71-4841-9C94-3DE7FCFB9230}">
                <p14:media xmlns:p14="http://schemas.microsoft.com/office/powerpoint/2010/main" r:embed="rId4">
                  <p14:trim st="201.6229" end="1209.7376"/>
                </p14:media>
              </p:ext>
            </p:extLst>
          </p:nvPr>
        </p:nvPicPr>
        <p:blipFill rotWithShape="1">
          <a:blip r:embed="rId7"/>
          <a:srcRect t="10588"/>
          <a:stretch>
            <a:fillRect/>
          </a:stretch>
        </p:blipFill>
        <p:spPr>
          <a:xfrm>
            <a:off x="6868908" y="938386"/>
            <a:ext cx="3508869" cy="3619052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8475281" y="2889025"/>
            <a:ext cx="404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FFCCFF"/>
                </a:solidFill>
              </a:rPr>
              <a:t>Tu</a:t>
            </a:r>
            <a:endParaRPr lang="de-DE" dirty="0">
              <a:solidFill>
                <a:srgbClr val="FFCCFF"/>
              </a:solidFill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7985504" y="4759982"/>
            <a:ext cx="3072316" cy="1334181"/>
            <a:chOff x="7985504" y="4759982"/>
            <a:chExt cx="3072316" cy="1334181"/>
          </a:xfrm>
        </p:grpSpPr>
        <p:grpSp>
          <p:nvGrpSpPr>
            <p:cNvPr id="51" name="Gruppieren 50"/>
            <p:cNvGrpSpPr/>
            <p:nvPr/>
          </p:nvGrpSpPr>
          <p:grpSpPr>
            <a:xfrm>
              <a:off x="7985504" y="4759982"/>
              <a:ext cx="3072316" cy="1334181"/>
              <a:chOff x="6407174" y="5412582"/>
              <a:chExt cx="2595231" cy="1073057"/>
            </a:xfrm>
          </p:grpSpPr>
          <p:grpSp>
            <p:nvGrpSpPr>
              <p:cNvPr id="46" name="Gruppieren 45"/>
              <p:cNvGrpSpPr/>
              <p:nvPr/>
            </p:nvGrpSpPr>
            <p:grpSpPr>
              <a:xfrm>
                <a:off x="6558586" y="5679699"/>
                <a:ext cx="2284878" cy="805940"/>
                <a:chOff x="5486960" y="5793517"/>
                <a:chExt cx="2284878" cy="805940"/>
              </a:xfrm>
            </p:grpSpPr>
            <p:sp>
              <p:nvSpPr>
                <p:cNvPr id="22" name="Rechteck 21"/>
                <p:cNvSpPr/>
                <p:nvPr/>
              </p:nvSpPr>
              <p:spPr>
                <a:xfrm>
                  <a:off x="5486960" y="5793517"/>
                  <a:ext cx="2284878" cy="805940"/>
                </a:xfrm>
                <a:custGeom>
                  <a:avLst/>
                  <a:gdLst>
                    <a:gd name="connsiteX0" fmla="*/ 0 w 2487993"/>
                    <a:gd name="connsiteY0" fmla="*/ 0 h 1136244"/>
                    <a:gd name="connsiteX1" fmla="*/ 2487993 w 2487993"/>
                    <a:gd name="connsiteY1" fmla="*/ 0 h 1136244"/>
                    <a:gd name="connsiteX2" fmla="*/ 2487993 w 2487993"/>
                    <a:gd name="connsiteY2" fmla="*/ 1136244 h 1136244"/>
                    <a:gd name="connsiteX3" fmla="*/ 0 w 2487993"/>
                    <a:gd name="connsiteY3" fmla="*/ 1136244 h 1136244"/>
                    <a:gd name="connsiteX4" fmla="*/ 0 w 2487993"/>
                    <a:gd name="connsiteY4" fmla="*/ 0 h 1136244"/>
                    <a:gd name="connsiteX0" fmla="*/ 0 w 2487993"/>
                    <a:gd name="connsiteY0" fmla="*/ 10633 h 1146877"/>
                    <a:gd name="connsiteX1" fmla="*/ 2296607 w 2487993"/>
                    <a:gd name="connsiteY1" fmla="*/ 0 h 1146877"/>
                    <a:gd name="connsiteX2" fmla="*/ 2487993 w 2487993"/>
                    <a:gd name="connsiteY2" fmla="*/ 1146877 h 1146877"/>
                    <a:gd name="connsiteX3" fmla="*/ 0 w 2487993"/>
                    <a:gd name="connsiteY3" fmla="*/ 1146877 h 1146877"/>
                    <a:gd name="connsiteX4" fmla="*/ 0 w 2487993"/>
                    <a:gd name="connsiteY4" fmla="*/ 10633 h 1146877"/>
                    <a:gd name="connsiteX0" fmla="*/ 116958 w 2487993"/>
                    <a:gd name="connsiteY0" fmla="*/ 21266 h 1146877"/>
                    <a:gd name="connsiteX1" fmla="*/ 2296607 w 2487993"/>
                    <a:gd name="connsiteY1" fmla="*/ 0 h 1146877"/>
                    <a:gd name="connsiteX2" fmla="*/ 2487993 w 2487993"/>
                    <a:gd name="connsiteY2" fmla="*/ 1146877 h 1146877"/>
                    <a:gd name="connsiteX3" fmla="*/ 0 w 2487993"/>
                    <a:gd name="connsiteY3" fmla="*/ 1146877 h 1146877"/>
                    <a:gd name="connsiteX4" fmla="*/ 116958 w 2487993"/>
                    <a:gd name="connsiteY4" fmla="*/ 21266 h 114687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487993" h="1146877">
                      <a:moveTo>
                        <a:pt x="116958" y="21266"/>
                      </a:moveTo>
                      <a:lnTo>
                        <a:pt x="2296607" y="0"/>
                      </a:lnTo>
                      <a:lnTo>
                        <a:pt x="2487993" y="1146877"/>
                      </a:lnTo>
                      <a:lnTo>
                        <a:pt x="0" y="1146877"/>
                      </a:lnTo>
                      <a:lnTo>
                        <a:pt x="116958" y="21266"/>
                      </a:lnTo>
                      <a:close/>
                    </a:path>
                  </a:pathLst>
                </a:cu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dirty="0"/>
                </a:p>
              </p:txBody>
            </p:sp>
            <p:grpSp>
              <p:nvGrpSpPr>
                <p:cNvPr id="33" name="Gruppieren 32"/>
                <p:cNvGrpSpPr/>
                <p:nvPr/>
              </p:nvGrpSpPr>
              <p:grpSpPr>
                <a:xfrm>
                  <a:off x="5561031" y="5795007"/>
                  <a:ext cx="2056813" cy="297565"/>
                  <a:chOff x="4800600" y="5675037"/>
                  <a:chExt cx="2980218" cy="359901"/>
                </a:xfrm>
              </p:grpSpPr>
              <p:sp>
                <p:nvSpPr>
                  <p:cNvPr id="27" name="Freihandform 26"/>
                  <p:cNvSpPr/>
                  <p:nvPr/>
                </p:nvSpPr>
                <p:spPr>
                  <a:xfrm>
                    <a:off x="4817394" y="5675037"/>
                    <a:ext cx="2963423" cy="319937"/>
                  </a:xfrm>
                  <a:custGeom>
                    <a:avLst/>
                    <a:gdLst>
                      <a:gd name="connsiteX0" fmla="*/ 0 w 3285941"/>
                      <a:gd name="connsiteY0" fmla="*/ 319126 h 460848"/>
                      <a:gd name="connsiteX1" fmla="*/ 510363 w 3285941"/>
                      <a:gd name="connsiteY1" fmla="*/ 212800 h 460848"/>
                      <a:gd name="connsiteX2" fmla="*/ 680484 w 3285941"/>
                      <a:gd name="connsiteY2" fmla="*/ 159638 h 460848"/>
                      <a:gd name="connsiteX3" fmla="*/ 1307805 w 3285941"/>
                      <a:gd name="connsiteY3" fmla="*/ 95842 h 460848"/>
                      <a:gd name="connsiteX4" fmla="*/ 1711842 w 3285941"/>
                      <a:gd name="connsiteY4" fmla="*/ 149005 h 460848"/>
                      <a:gd name="connsiteX5" fmla="*/ 2275368 w 3285941"/>
                      <a:gd name="connsiteY5" fmla="*/ 149 h 460848"/>
                      <a:gd name="connsiteX6" fmla="*/ 2881424 w 3285941"/>
                      <a:gd name="connsiteY6" fmla="*/ 180903 h 460848"/>
                      <a:gd name="connsiteX7" fmla="*/ 2190307 w 3285941"/>
                      <a:gd name="connsiteY7" fmla="*/ 95842 h 460848"/>
                      <a:gd name="connsiteX8" fmla="*/ 3189768 w 3285941"/>
                      <a:gd name="connsiteY8" fmla="*/ 425452 h 460848"/>
                      <a:gd name="connsiteX9" fmla="*/ 3189768 w 3285941"/>
                      <a:gd name="connsiteY9" fmla="*/ 436084 h 460848"/>
                      <a:gd name="connsiteX0" fmla="*/ 0 w 3231046"/>
                      <a:gd name="connsiteY0" fmla="*/ 319126 h 454709"/>
                      <a:gd name="connsiteX1" fmla="*/ 510363 w 3231046"/>
                      <a:gd name="connsiteY1" fmla="*/ 212800 h 454709"/>
                      <a:gd name="connsiteX2" fmla="*/ 680484 w 3231046"/>
                      <a:gd name="connsiteY2" fmla="*/ 159638 h 454709"/>
                      <a:gd name="connsiteX3" fmla="*/ 1307805 w 3231046"/>
                      <a:gd name="connsiteY3" fmla="*/ 95842 h 454709"/>
                      <a:gd name="connsiteX4" fmla="*/ 1711842 w 3231046"/>
                      <a:gd name="connsiteY4" fmla="*/ 149005 h 454709"/>
                      <a:gd name="connsiteX5" fmla="*/ 2275368 w 3231046"/>
                      <a:gd name="connsiteY5" fmla="*/ 149 h 454709"/>
                      <a:gd name="connsiteX6" fmla="*/ 2881424 w 3231046"/>
                      <a:gd name="connsiteY6" fmla="*/ 180903 h 454709"/>
                      <a:gd name="connsiteX7" fmla="*/ 3083442 w 3231046"/>
                      <a:gd name="connsiteY7" fmla="*/ 191535 h 454709"/>
                      <a:gd name="connsiteX8" fmla="*/ 3189768 w 3231046"/>
                      <a:gd name="connsiteY8" fmla="*/ 425452 h 454709"/>
                      <a:gd name="connsiteX9" fmla="*/ 3189768 w 3231046"/>
                      <a:gd name="connsiteY9" fmla="*/ 436084 h 454709"/>
                      <a:gd name="connsiteX0" fmla="*/ 0 w 3320449"/>
                      <a:gd name="connsiteY0" fmla="*/ 319126 h 546407"/>
                      <a:gd name="connsiteX1" fmla="*/ 510363 w 3320449"/>
                      <a:gd name="connsiteY1" fmla="*/ 212800 h 546407"/>
                      <a:gd name="connsiteX2" fmla="*/ 680484 w 3320449"/>
                      <a:gd name="connsiteY2" fmla="*/ 159638 h 546407"/>
                      <a:gd name="connsiteX3" fmla="*/ 1307805 w 3320449"/>
                      <a:gd name="connsiteY3" fmla="*/ 95842 h 546407"/>
                      <a:gd name="connsiteX4" fmla="*/ 1711842 w 3320449"/>
                      <a:gd name="connsiteY4" fmla="*/ 149005 h 546407"/>
                      <a:gd name="connsiteX5" fmla="*/ 2275368 w 3320449"/>
                      <a:gd name="connsiteY5" fmla="*/ 149 h 546407"/>
                      <a:gd name="connsiteX6" fmla="*/ 2881424 w 3320449"/>
                      <a:gd name="connsiteY6" fmla="*/ 180903 h 546407"/>
                      <a:gd name="connsiteX7" fmla="*/ 3083442 w 3320449"/>
                      <a:gd name="connsiteY7" fmla="*/ 191535 h 546407"/>
                      <a:gd name="connsiteX8" fmla="*/ 3189768 w 3320449"/>
                      <a:gd name="connsiteY8" fmla="*/ 425452 h 546407"/>
                      <a:gd name="connsiteX9" fmla="*/ 3296093 w 3320449"/>
                      <a:gd name="connsiteY9" fmla="*/ 542410 h 546407"/>
                      <a:gd name="connsiteX0" fmla="*/ 0 w 3317336"/>
                      <a:gd name="connsiteY0" fmla="*/ 319126 h 543786"/>
                      <a:gd name="connsiteX1" fmla="*/ 510363 w 3317336"/>
                      <a:gd name="connsiteY1" fmla="*/ 212800 h 543786"/>
                      <a:gd name="connsiteX2" fmla="*/ 680484 w 3317336"/>
                      <a:gd name="connsiteY2" fmla="*/ 159638 h 543786"/>
                      <a:gd name="connsiteX3" fmla="*/ 1307805 w 3317336"/>
                      <a:gd name="connsiteY3" fmla="*/ 95842 h 543786"/>
                      <a:gd name="connsiteX4" fmla="*/ 1711842 w 3317336"/>
                      <a:gd name="connsiteY4" fmla="*/ 149005 h 543786"/>
                      <a:gd name="connsiteX5" fmla="*/ 2275368 w 3317336"/>
                      <a:gd name="connsiteY5" fmla="*/ 149 h 543786"/>
                      <a:gd name="connsiteX6" fmla="*/ 2881424 w 3317336"/>
                      <a:gd name="connsiteY6" fmla="*/ 180903 h 543786"/>
                      <a:gd name="connsiteX7" fmla="*/ 3083442 w 3317336"/>
                      <a:gd name="connsiteY7" fmla="*/ 191535 h 543786"/>
                      <a:gd name="connsiteX8" fmla="*/ 3157870 w 3317336"/>
                      <a:gd name="connsiteY8" fmla="*/ 234065 h 543786"/>
                      <a:gd name="connsiteX9" fmla="*/ 3296093 w 3317336"/>
                      <a:gd name="connsiteY9" fmla="*/ 542410 h 543786"/>
                      <a:gd name="connsiteX0" fmla="*/ 0 w 3164686"/>
                      <a:gd name="connsiteY0" fmla="*/ 319126 h 319126"/>
                      <a:gd name="connsiteX1" fmla="*/ 510363 w 3164686"/>
                      <a:gd name="connsiteY1" fmla="*/ 212800 h 319126"/>
                      <a:gd name="connsiteX2" fmla="*/ 680484 w 3164686"/>
                      <a:gd name="connsiteY2" fmla="*/ 159638 h 319126"/>
                      <a:gd name="connsiteX3" fmla="*/ 1307805 w 3164686"/>
                      <a:gd name="connsiteY3" fmla="*/ 95842 h 319126"/>
                      <a:gd name="connsiteX4" fmla="*/ 1711842 w 3164686"/>
                      <a:gd name="connsiteY4" fmla="*/ 149005 h 319126"/>
                      <a:gd name="connsiteX5" fmla="*/ 2275368 w 3164686"/>
                      <a:gd name="connsiteY5" fmla="*/ 149 h 319126"/>
                      <a:gd name="connsiteX6" fmla="*/ 2881424 w 3164686"/>
                      <a:gd name="connsiteY6" fmla="*/ 180903 h 319126"/>
                      <a:gd name="connsiteX7" fmla="*/ 3083442 w 3164686"/>
                      <a:gd name="connsiteY7" fmla="*/ 191535 h 319126"/>
                      <a:gd name="connsiteX8" fmla="*/ 3157870 w 3164686"/>
                      <a:gd name="connsiteY8" fmla="*/ 234065 h 319126"/>
                      <a:gd name="connsiteX9" fmla="*/ 3104707 w 3164686"/>
                      <a:gd name="connsiteY9" fmla="*/ 212801 h 319126"/>
                      <a:gd name="connsiteX0" fmla="*/ 0 w 3164686"/>
                      <a:gd name="connsiteY0" fmla="*/ 319126 h 319126"/>
                      <a:gd name="connsiteX1" fmla="*/ 510363 w 3164686"/>
                      <a:gd name="connsiteY1" fmla="*/ 212800 h 319126"/>
                      <a:gd name="connsiteX2" fmla="*/ 680484 w 3164686"/>
                      <a:gd name="connsiteY2" fmla="*/ 159638 h 319126"/>
                      <a:gd name="connsiteX3" fmla="*/ 1307805 w 3164686"/>
                      <a:gd name="connsiteY3" fmla="*/ 95842 h 319126"/>
                      <a:gd name="connsiteX4" fmla="*/ 1711842 w 3164686"/>
                      <a:gd name="connsiteY4" fmla="*/ 149005 h 319126"/>
                      <a:gd name="connsiteX5" fmla="*/ 2275368 w 3164686"/>
                      <a:gd name="connsiteY5" fmla="*/ 149 h 319126"/>
                      <a:gd name="connsiteX6" fmla="*/ 2881424 w 3164686"/>
                      <a:gd name="connsiteY6" fmla="*/ 180903 h 319126"/>
                      <a:gd name="connsiteX7" fmla="*/ 3157870 w 3164686"/>
                      <a:gd name="connsiteY7" fmla="*/ 234065 h 319126"/>
                      <a:gd name="connsiteX8" fmla="*/ 3104707 w 3164686"/>
                      <a:gd name="connsiteY8" fmla="*/ 212801 h 319126"/>
                      <a:gd name="connsiteX0" fmla="*/ 0 w 3157870"/>
                      <a:gd name="connsiteY0" fmla="*/ 319126 h 319126"/>
                      <a:gd name="connsiteX1" fmla="*/ 510363 w 3157870"/>
                      <a:gd name="connsiteY1" fmla="*/ 212800 h 319126"/>
                      <a:gd name="connsiteX2" fmla="*/ 680484 w 3157870"/>
                      <a:gd name="connsiteY2" fmla="*/ 159638 h 319126"/>
                      <a:gd name="connsiteX3" fmla="*/ 1307805 w 3157870"/>
                      <a:gd name="connsiteY3" fmla="*/ 95842 h 319126"/>
                      <a:gd name="connsiteX4" fmla="*/ 1711842 w 3157870"/>
                      <a:gd name="connsiteY4" fmla="*/ 149005 h 319126"/>
                      <a:gd name="connsiteX5" fmla="*/ 2275368 w 3157870"/>
                      <a:gd name="connsiteY5" fmla="*/ 149 h 319126"/>
                      <a:gd name="connsiteX6" fmla="*/ 2881424 w 3157870"/>
                      <a:gd name="connsiteY6" fmla="*/ 180903 h 319126"/>
                      <a:gd name="connsiteX7" fmla="*/ 3157870 w 3157870"/>
                      <a:gd name="connsiteY7" fmla="*/ 234065 h 319126"/>
                      <a:gd name="connsiteX0" fmla="*/ 0 w 3157870"/>
                      <a:gd name="connsiteY0" fmla="*/ 319938 h 319938"/>
                      <a:gd name="connsiteX1" fmla="*/ 510363 w 3157870"/>
                      <a:gd name="connsiteY1" fmla="*/ 213612 h 319938"/>
                      <a:gd name="connsiteX2" fmla="*/ 680484 w 3157870"/>
                      <a:gd name="connsiteY2" fmla="*/ 160450 h 319938"/>
                      <a:gd name="connsiteX3" fmla="*/ 1307805 w 3157870"/>
                      <a:gd name="connsiteY3" fmla="*/ 96654 h 319938"/>
                      <a:gd name="connsiteX4" fmla="*/ 1711842 w 3157870"/>
                      <a:gd name="connsiteY4" fmla="*/ 149817 h 319938"/>
                      <a:gd name="connsiteX5" fmla="*/ 2275368 w 3157870"/>
                      <a:gd name="connsiteY5" fmla="*/ 961 h 319938"/>
                      <a:gd name="connsiteX6" fmla="*/ 3157870 w 3157870"/>
                      <a:gd name="connsiteY6" fmla="*/ 234877 h 319938"/>
                      <a:gd name="connsiteX0" fmla="*/ 0 w 3157870"/>
                      <a:gd name="connsiteY0" fmla="*/ 319938 h 319938"/>
                      <a:gd name="connsiteX1" fmla="*/ 510363 w 3157870"/>
                      <a:gd name="connsiteY1" fmla="*/ 213612 h 319938"/>
                      <a:gd name="connsiteX2" fmla="*/ 680484 w 3157870"/>
                      <a:gd name="connsiteY2" fmla="*/ 160450 h 319938"/>
                      <a:gd name="connsiteX3" fmla="*/ 1307805 w 3157870"/>
                      <a:gd name="connsiteY3" fmla="*/ 96654 h 319938"/>
                      <a:gd name="connsiteX4" fmla="*/ 1711842 w 3157870"/>
                      <a:gd name="connsiteY4" fmla="*/ 149817 h 319938"/>
                      <a:gd name="connsiteX5" fmla="*/ 2488019 w 3157870"/>
                      <a:gd name="connsiteY5" fmla="*/ 961 h 319938"/>
                      <a:gd name="connsiteX6" fmla="*/ 3157870 w 3157870"/>
                      <a:gd name="connsiteY6" fmla="*/ 234877 h 31993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</a:cxnLst>
                    <a:rect l="l" t="t" r="r" b="b"/>
                    <a:pathLst>
                      <a:path w="3157870" h="319938">
                        <a:moveTo>
                          <a:pt x="0" y="319938"/>
                        </a:moveTo>
                        <a:lnTo>
                          <a:pt x="510363" y="213612"/>
                        </a:lnTo>
                        <a:cubicBezTo>
                          <a:pt x="623777" y="187031"/>
                          <a:pt x="547577" y="179943"/>
                          <a:pt x="680484" y="160450"/>
                        </a:cubicBezTo>
                        <a:cubicBezTo>
                          <a:pt x="813391" y="140957"/>
                          <a:pt x="1135912" y="98426"/>
                          <a:pt x="1307805" y="96654"/>
                        </a:cubicBezTo>
                        <a:cubicBezTo>
                          <a:pt x="1479698" y="94882"/>
                          <a:pt x="1515140" y="165766"/>
                          <a:pt x="1711842" y="149817"/>
                        </a:cubicBezTo>
                        <a:cubicBezTo>
                          <a:pt x="1908544" y="133868"/>
                          <a:pt x="2247014" y="-13216"/>
                          <a:pt x="2488019" y="961"/>
                        </a:cubicBezTo>
                        <a:cubicBezTo>
                          <a:pt x="2729024" y="15138"/>
                          <a:pt x="2974016" y="186145"/>
                          <a:pt x="3157870" y="234877"/>
                        </a:cubicBezTo>
                      </a:path>
                    </a:pathLst>
                  </a:custGeom>
                  <a:noFill/>
                  <a:ln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  <p:sp>
                <p:nvSpPr>
                  <p:cNvPr id="28" name="Freihandform 27"/>
                  <p:cNvSpPr/>
                  <p:nvPr/>
                </p:nvSpPr>
                <p:spPr>
                  <a:xfrm>
                    <a:off x="4800600" y="5715001"/>
                    <a:ext cx="2980218" cy="319937"/>
                  </a:xfrm>
                  <a:custGeom>
                    <a:avLst/>
                    <a:gdLst>
                      <a:gd name="connsiteX0" fmla="*/ 0 w 3285941"/>
                      <a:gd name="connsiteY0" fmla="*/ 319126 h 460848"/>
                      <a:gd name="connsiteX1" fmla="*/ 510363 w 3285941"/>
                      <a:gd name="connsiteY1" fmla="*/ 212800 h 460848"/>
                      <a:gd name="connsiteX2" fmla="*/ 680484 w 3285941"/>
                      <a:gd name="connsiteY2" fmla="*/ 159638 h 460848"/>
                      <a:gd name="connsiteX3" fmla="*/ 1307805 w 3285941"/>
                      <a:gd name="connsiteY3" fmla="*/ 95842 h 460848"/>
                      <a:gd name="connsiteX4" fmla="*/ 1711842 w 3285941"/>
                      <a:gd name="connsiteY4" fmla="*/ 149005 h 460848"/>
                      <a:gd name="connsiteX5" fmla="*/ 2275368 w 3285941"/>
                      <a:gd name="connsiteY5" fmla="*/ 149 h 460848"/>
                      <a:gd name="connsiteX6" fmla="*/ 2881424 w 3285941"/>
                      <a:gd name="connsiteY6" fmla="*/ 180903 h 460848"/>
                      <a:gd name="connsiteX7" fmla="*/ 2190307 w 3285941"/>
                      <a:gd name="connsiteY7" fmla="*/ 95842 h 460848"/>
                      <a:gd name="connsiteX8" fmla="*/ 3189768 w 3285941"/>
                      <a:gd name="connsiteY8" fmla="*/ 425452 h 460848"/>
                      <a:gd name="connsiteX9" fmla="*/ 3189768 w 3285941"/>
                      <a:gd name="connsiteY9" fmla="*/ 436084 h 460848"/>
                      <a:gd name="connsiteX0" fmla="*/ 0 w 3231046"/>
                      <a:gd name="connsiteY0" fmla="*/ 319126 h 454709"/>
                      <a:gd name="connsiteX1" fmla="*/ 510363 w 3231046"/>
                      <a:gd name="connsiteY1" fmla="*/ 212800 h 454709"/>
                      <a:gd name="connsiteX2" fmla="*/ 680484 w 3231046"/>
                      <a:gd name="connsiteY2" fmla="*/ 159638 h 454709"/>
                      <a:gd name="connsiteX3" fmla="*/ 1307805 w 3231046"/>
                      <a:gd name="connsiteY3" fmla="*/ 95842 h 454709"/>
                      <a:gd name="connsiteX4" fmla="*/ 1711842 w 3231046"/>
                      <a:gd name="connsiteY4" fmla="*/ 149005 h 454709"/>
                      <a:gd name="connsiteX5" fmla="*/ 2275368 w 3231046"/>
                      <a:gd name="connsiteY5" fmla="*/ 149 h 454709"/>
                      <a:gd name="connsiteX6" fmla="*/ 2881424 w 3231046"/>
                      <a:gd name="connsiteY6" fmla="*/ 180903 h 454709"/>
                      <a:gd name="connsiteX7" fmla="*/ 3083442 w 3231046"/>
                      <a:gd name="connsiteY7" fmla="*/ 191535 h 454709"/>
                      <a:gd name="connsiteX8" fmla="*/ 3189768 w 3231046"/>
                      <a:gd name="connsiteY8" fmla="*/ 425452 h 454709"/>
                      <a:gd name="connsiteX9" fmla="*/ 3189768 w 3231046"/>
                      <a:gd name="connsiteY9" fmla="*/ 436084 h 454709"/>
                      <a:gd name="connsiteX0" fmla="*/ 0 w 3320449"/>
                      <a:gd name="connsiteY0" fmla="*/ 319126 h 546407"/>
                      <a:gd name="connsiteX1" fmla="*/ 510363 w 3320449"/>
                      <a:gd name="connsiteY1" fmla="*/ 212800 h 546407"/>
                      <a:gd name="connsiteX2" fmla="*/ 680484 w 3320449"/>
                      <a:gd name="connsiteY2" fmla="*/ 159638 h 546407"/>
                      <a:gd name="connsiteX3" fmla="*/ 1307805 w 3320449"/>
                      <a:gd name="connsiteY3" fmla="*/ 95842 h 546407"/>
                      <a:gd name="connsiteX4" fmla="*/ 1711842 w 3320449"/>
                      <a:gd name="connsiteY4" fmla="*/ 149005 h 546407"/>
                      <a:gd name="connsiteX5" fmla="*/ 2275368 w 3320449"/>
                      <a:gd name="connsiteY5" fmla="*/ 149 h 546407"/>
                      <a:gd name="connsiteX6" fmla="*/ 2881424 w 3320449"/>
                      <a:gd name="connsiteY6" fmla="*/ 180903 h 546407"/>
                      <a:gd name="connsiteX7" fmla="*/ 3083442 w 3320449"/>
                      <a:gd name="connsiteY7" fmla="*/ 191535 h 546407"/>
                      <a:gd name="connsiteX8" fmla="*/ 3189768 w 3320449"/>
                      <a:gd name="connsiteY8" fmla="*/ 425452 h 546407"/>
                      <a:gd name="connsiteX9" fmla="*/ 3296093 w 3320449"/>
                      <a:gd name="connsiteY9" fmla="*/ 542410 h 546407"/>
                      <a:gd name="connsiteX0" fmla="*/ 0 w 3317336"/>
                      <a:gd name="connsiteY0" fmla="*/ 319126 h 543786"/>
                      <a:gd name="connsiteX1" fmla="*/ 510363 w 3317336"/>
                      <a:gd name="connsiteY1" fmla="*/ 212800 h 543786"/>
                      <a:gd name="connsiteX2" fmla="*/ 680484 w 3317336"/>
                      <a:gd name="connsiteY2" fmla="*/ 159638 h 543786"/>
                      <a:gd name="connsiteX3" fmla="*/ 1307805 w 3317336"/>
                      <a:gd name="connsiteY3" fmla="*/ 95842 h 543786"/>
                      <a:gd name="connsiteX4" fmla="*/ 1711842 w 3317336"/>
                      <a:gd name="connsiteY4" fmla="*/ 149005 h 543786"/>
                      <a:gd name="connsiteX5" fmla="*/ 2275368 w 3317336"/>
                      <a:gd name="connsiteY5" fmla="*/ 149 h 543786"/>
                      <a:gd name="connsiteX6" fmla="*/ 2881424 w 3317336"/>
                      <a:gd name="connsiteY6" fmla="*/ 180903 h 543786"/>
                      <a:gd name="connsiteX7" fmla="*/ 3083442 w 3317336"/>
                      <a:gd name="connsiteY7" fmla="*/ 191535 h 543786"/>
                      <a:gd name="connsiteX8" fmla="*/ 3157870 w 3317336"/>
                      <a:gd name="connsiteY8" fmla="*/ 234065 h 543786"/>
                      <a:gd name="connsiteX9" fmla="*/ 3296093 w 3317336"/>
                      <a:gd name="connsiteY9" fmla="*/ 542410 h 543786"/>
                      <a:gd name="connsiteX0" fmla="*/ 0 w 3164686"/>
                      <a:gd name="connsiteY0" fmla="*/ 319126 h 319126"/>
                      <a:gd name="connsiteX1" fmla="*/ 510363 w 3164686"/>
                      <a:gd name="connsiteY1" fmla="*/ 212800 h 319126"/>
                      <a:gd name="connsiteX2" fmla="*/ 680484 w 3164686"/>
                      <a:gd name="connsiteY2" fmla="*/ 159638 h 319126"/>
                      <a:gd name="connsiteX3" fmla="*/ 1307805 w 3164686"/>
                      <a:gd name="connsiteY3" fmla="*/ 95842 h 319126"/>
                      <a:gd name="connsiteX4" fmla="*/ 1711842 w 3164686"/>
                      <a:gd name="connsiteY4" fmla="*/ 149005 h 319126"/>
                      <a:gd name="connsiteX5" fmla="*/ 2275368 w 3164686"/>
                      <a:gd name="connsiteY5" fmla="*/ 149 h 319126"/>
                      <a:gd name="connsiteX6" fmla="*/ 2881424 w 3164686"/>
                      <a:gd name="connsiteY6" fmla="*/ 180903 h 319126"/>
                      <a:gd name="connsiteX7" fmla="*/ 3083442 w 3164686"/>
                      <a:gd name="connsiteY7" fmla="*/ 191535 h 319126"/>
                      <a:gd name="connsiteX8" fmla="*/ 3157870 w 3164686"/>
                      <a:gd name="connsiteY8" fmla="*/ 234065 h 319126"/>
                      <a:gd name="connsiteX9" fmla="*/ 3104707 w 3164686"/>
                      <a:gd name="connsiteY9" fmla="*/ 212801 h 319126"/>
                      <a:gd name="connsiteX0" fmla="*/ 0 w 3164686"/>
                      <a:gd name="connsiteY0" fmla="*/ 319126 h 319126"/>
                      <a:gd name="connsiteX1" fmla="*/ 510363 w 3164686"/>
                      <a:gd name="connsiteY1" fmla="*/ 212800 h 319126"/>
                      <a:gd name="connsiteX2" fmla="*/ 680484 w 3164686"/>
                      <a:gd name="connsiteY2" fmla="*/ 159638 h 319126"/>
                      <a:gd name="connsiteX3" fmla="*/ 1307805 w 3164686"/>
                      <a:gd name="connsiteY3" fmla="*/ 95842 h 319126"/>
                      <a:gd name="connsiteX4" fmla="*/ 1711842 w 3164686"/>
                      <a:gd name="connsiteY4" fmla="*/ 149005 h 319126"/>
                      <a:gd name="connsiteX5" fmla="*/ 2275368 w 3164686"/>
                      <a:gd name="connsiteY5" fmla="*/ 149 h 319126"/>
                      <a:gd name="connsiteX6" fmla="*/ 2881424 w 3164686"/>
                      <a:gd name="connsiteY6" fmla="*/ 180903 h 319126"/>
                      <a:gd name="connsiteX7" fmla="*/ 3157870 w 3164686"/>
                      <a:gd name="connsiteY7" fmla="*/ 234065 h 319126"/>
                      <a:gd name="connsiteX8" fmla="*/ 3104707 w 3164686"/>
                      <a:gd name="connsiteY8" fmla="*/ 212801 h 319126"/>
                      <a:gd name="connsiteX0" fmla="*/ 0 w 3157870"/>
                      <a:gd name="connsiteY0" fmla="*/ 319126 h 319126"/>
                      <a:gd name="connsiteX1" fmla="*/ 510363 w 3157870"/>
                      <a:gd name="connsiteY1" fmla="*/ 212800 h 319126"/>
                      <a:gd name="connsiteX2" fmla="*/ 680484 w 3157870"/>
                      <a:gd name="connsiteY2" fmla="*/ 159638 h 319126"/>
                      <a:gd name="connsiteX3" fmla="*/ 1307805 w 3157870"/>
                      <a:gd name="connsiteY3" fmla="*/ 95842 h 319126"/>
                      <a:gd name="connsiteX4" fmla="*/ 1711842 w 3157870"/>
                      <a:gd name="connsiteY4" fmla="*/ 149005 h 319126"/>
                      <a:gd name="connsiteX5" fmla="*/ 2275368 w 3157870"/>
                      <a:gd name="connsiteY5" fmla="*/ 149 h 319126"/>
                      <a:gd name="connsiteX6" fmla="*/ 2881424 w 3157870"/>
                      <a:gd name="connsiteY6" fmla="*/ 180903 h 319126"/>
                      <a:gd name="connsiteX7" fmla="*/ 3157870 w 3157870"/>
                      <a:gd name="connsiteY7" fmla="*/ 234065 h 319126"/>
                      <a:gd name="connsiteX0" fmla="*/ 0 w 3157870"/>
                      <a:gd name="connsiteY0" fmla="*/ 319938 h 319938"/>
                      <a:gd name="connsiteX1" fmla="*/ 510363 w 3157870"/>
                      <a:gd name="connsiteY1" fmla="*/ 213612 h 319938"/>
                      <a:gd name="connsiteX2" fmla="*/ 680484 w 3157870"/>
                      <a:gd name="connsiteY2" fmla="*/ 160450 h 319938"/>
                      <a:gd name="connsiteX3" fmla="*/ 1307805 w 3157870"/>
                      <a:gd name="connsiteY3" fmla="*/ 96654 h 319938"/>
                      <a:gd name="connsiteX4" fmla="*/ 1711842 w 3157870"/>
                      <a:gd name="connsiteY4" fmla="*/ 149817 h 319938"/>
                      <a:gd name="connsiteX5" fmla="*/ 2275368 w 3157870"/>
                      <a:gd name="connsiteY5" fmla="*/ 961 h 319938"/>
                      <a:gd name="connsiteX6" fmla="*/ 3157870 w 3157870"/>
                      <a:gd name="connsiteY6" fmla="*/ 234877 h 319938"/>
                      <a:gd name="connsiteX0" fmla="*/ 0 w 3157870"/>
                      <a:gd name="connsiteY0" fmla="*/ 319938 h 319938"/>
                      <a:gd name="connsiteX1" fmla="*/ 510363 w 3157870"/>
                      <a:gd name="connsiteY1" fmla="*/ 213612 h 319938"/>
                      <a:gd name="connsiteX2" fmla="*/ 680484 w 3157870"/>
                      <a:gd name="connsiteY2" fmla="*/ 160450 h 319938"/>
                      <a:gd name="connsiteX3" fmla="*/ 1307805 w 3157870"/>
                      <a:gd name="connsiteY3" fmla="*/ 96654 h 319938"/>
                      <a:gd name="connsiteX4" fmla="*/ 1711842 w 3157870"/>
                      <a:gd name="connsiteY4" fmla="*/ 149817 h 319938"/>
                      <a:gd name="connsiteX5" fmla="*/ 2488019 w 3157870"/>
                      <a:gd name="connsiteY5" fmla="*/ 961 h 319938"/>
                      <a:gd name="connsiteX6" fmla="*/ 3157870 w 3157870"/>
                      <a:gd name="connsiteY6" fmla="*/ 234877 h 31993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</a:cxnLst>
                    <a:rect l="l" t="t" r="r" b="b"/>
                    <a:pathLst>
                      <a:path w="3157870" h="319938">
                        <a:moveTo>
                          <a:pt x="0" y="319938"/>
                        </a:moveTo>
                        <a:lnTo>
                          <a:pt x="510363" y="213612"/>
                        </a:lnTo>
                        <a:cubicBezTo>
                          <a:pt x="623777" y="187031"/>
                          <a:pt x="547577" y="179943"/>
                          <a:pt x="680484" y="160450"/>
                        </a:cubicBezTo>
                        <a:cubicBezTo>
                          <a:pt x="813391" y="140957"/>
                          <a:pt x="1135912" y="98426"/>
                          <a:pt x="1307805" y="96654"/>
                        </a:cubicBezTo>
                        <a:cubicBezTo>
                          <a:pt x="1479698" y="94882"/>
                          <a:pt x="1515140" y="165766"/>
                          <a:pt x="1711842" y="149817"/>
                        </a:cubicBezTo>
                        <a:cubicBezTo>
                          <a:pt x="1908544" y="133868"/>
                          <a:pt x="2247014" y="-13216"/>
                          <a:pt x="2488019" y="961"/>
                        </a:cubicBezTo>
                        <a:cubicBezTo>
                          <a:pt x="2729024" y="15138"/>
                          <a:pt x="2974016" y="186145"/>
                          <a:pt x="3157870" y="234877"/>
                        </a:cubicBezTo>
                      </a:path>
                    </a:pathLst>
                  </a:custGeom>
                  <a:noFill/>
                  <a:ln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</p:grpSp>
            <p:sp>
              <p:nvSpPr>
                <p:cNvPr id="31" name="Freihandform 30"/>
                <p:cNvSpPr/>
                <p:nvPr/>
              </p:nvSpPr>
              <p:spPr>
                <a:xfrm>
                  <a:off x="5862278" y="5938548"/>
                  <a:ext cx="914400" cy="515874"/>
                </a:xfrm>
                <a:custGeom>
                  <a:avLst/>
                  <a:gdLst>
                    <a:gd name="connsiteX0" fmla="*/ 85060 w 1275907"/>
                    <a:gd name="connsiteY0" fmla="*/ 170121 h 575671"/>
                    <a:gd name="connsiteX1" fmla="*/ 138223 w 1275907"/>
                    <a:gd name="connsiteY1" fmla="*/ 148856 h 575671"/>
                    <a:gd name="connsiteX2" fmla="*/ 170121 w 1275907"/>
                    <a:gd name="connsiteY2" fmla="*/ 127591 h 575671"/>
                    <a:gd name="connsiteX3" fmla="*/ 233916 w 1275907"/>
                    <a:gd name="connsiteY3" fmla="*/ 106326 h 575671"/>
                    <a:gd name="connsiteX4" fmla="*/ 318977 w 1275907"/>
                    <a:gd name="connsiteY4" fmla="*/ 85061 h 575671"/>
                    <a:gd name="connsiteX5" fmla="*/ 340242 w 1275907"/>
                    <a:gd name="connsiteY5" fmla="*/ 63795 h 575671"/>
                    <a:gd name="connsiteX6" fmla="*/ 499730 w 1275907"/>
                    <a:gd name="connsiteY6" fmla="*/ 31898 h 575671"/>
                    <a:gd name="connsiteX7" fmla="*/ 531628 w 1275907"/>
                    <a:gd name="connsiteY7" fmla="*/ 21265 h 575671"/>
                    <a:gd name="connsiteX8" fmla="*/ 595423 w 1275907"/>
                    <a:gd name="connsiteY8" fmla="*/ 10633 h 575671"/>
                    <a:gd name="connsiteX9" fmla="*/ 637953 w 1275907"/>
                    <a:gd name="connsiteY9" fmla="*/ 0 h 575671"/>
                    <a:gd name="connsiteX10" fmla="*/ 765544 w 1275907"/>
                    <a:gd name="connsiteY10" fmla="*/ 21265 h 575671"/>
                    <a:gd name="connsiteX11" fmla="*/ 797442 w 1275907"/>
                    <a:gd name="connsiteY11" fmla="*/ 42530 h 575671"/>
                    <a:gd name="connsiteX12" fmla="*/ 818707 w 1275907"/>
                    <a:gd name="connsiteY12" fmla="*/ 74428 h 575671"/>
                    <a:gd name="connsiteX13" fmla="*/ 882502 w 1275907"/>
                    <a:gd name="connsiteY13" fmla="*/ 95693 h 575671"/>
                    <a:gd name="connsiteX14" fmla="*/ 914400 w 1275907"/>
                    <a:gd name="connsiteY14" fmla="*/ 116958 h 575671"/>
                    <a:gd name="connsiteX15" fmla="*/ 946298 w 1275907"/>
                    <a:gd name="connsiteY15" fmla="*/ 127591 h 575671"/>
                    <a:gd name="connsiteX16" fmla="*/ 1031358 w 1275907"/>
                    <a:gd name="connsiteY16" fmla="*/ 148856 h 575671"/>
                    <a:gd name="connsiteX17" fmla="*/ 1095153 w 1275907"/>
                    <a:gd name="connsiteY17" fmla="*/ 170121 h 575671"/>
                    <a:gd name="connsiteX18" fmla="*/ 1127051 w 1275907"/>
                    <a:gd name="connsiteY18" fmla="*/ 180754 h 575671"/>
                    <a:gd name="connsiteX19" fmla="*/ 1169581 w 1275907"/>
                    <a:gd name="connsiteY19" fmla="*/ 202019 h 575671"/>
                    <a:gd name="connsiteX20" fmla="*/ 1201479 w 1275907"/>
                    <a:gd name="connsiteY20" fmla="*/ 212651 h 575671"/>
                    <a:gd name="connsiteX21" fmla="*/ 1254642 w 1275907"/>
                    <a:gd name="connsiteY21" fmla="*/ 244549 h 575671"/>
                    <a:gd name="connsiteX22" fmla="*/ 1265274 w 1275907"/>
                    <a:gd name="connsiteY22" fmla="*/ 329609 h 575671"/>
                    <a:gd name="connsiteX23" fmla="*/ 1275907 w 1275907"/>
                    <a:gd name="connsiteY23" fmla="*/ 361507 h 575671"/>
                    <a:gd name="connsiteX24" fmla="*/ 1265274 w 1275907"/>
                    <a:gd name="connsiteY24" fmla="*/ 393405 h 575671"/>
                    <a:gd name="connsiteX25" fmla="*/ 1222744 w 1275907"/>
                    <a:gd name="connsiteY25" fmla="*/ 404037 h 575671"/>
                    <a:gd name="connsiteX26" fmla="*/ 1222744 w 1275907"/>
                    <a:gd name="connsiteY26" fmla="*/ 510363 h 575671"/>
                    <a:gd name="connsiteX27" fmla="*/ 1180214 w 1275907"/>
                    <a:gd name="connsiteY27" fmla="*/ 520995 h 575671"/>
                    <a:gd name="connsiteX28" fmla="*/ 1116418 w 1275907"/>
                    <a:gd name="connsiteY28" fmla="*/ 542261 h 575671"/>
                    <a:gd name="connsiteX29" fmla="*/ 1095153 w 1275907"/>
                    <a:gd name="connsiteY29" fmla="*/ 574158 h 575671"/>
                    <a:gd name="connsiteX30" fmla="*/ 956930 w 1275907"/>
                    <a:gd name="connsiteY30" fmla="*/ 563526 h 575671"/>
                    <a:gd name="connsiteX31" fmla="*/ 712381 w 1275907"/>
                    <a:gd name="connsiteY31" fmla="*/ 552893 h 575671"/>
                    <a:gd name="connsiteX32" fmla="*/ 606056 w 1275907"/>
                    <a:gd name="connsiteY32" fmla="*/ 531628 h 575671"/>
                    <a:gd name="connsiteX33" fmla="*/ 542260 w 1275907"/>
                    <a:gd name="connsiteY33" fmla="*/ 499730 h 575671"/>
                    <a:gd name="connsiteX34" fmla="*/ 520995 w 1275907"/>
                    <a:gd name="connsiteY34" fmla="*/ 467833 h 575671"/>
                    <a:gd name="connsiteX35" fmla="*/ 457200 w 1275907"/>
                    <a:gd name="connsiteY35" fmla="*/ 446568 h 575671"/>
                    <a:gd name="connsiteX36" fmla="*/ 393405 w 1275907"/>
                    <a:gd name="connsiteY36" fmla="*/ 467833 h 575671"/>
                    <a:gd name="connsiteX37" fmla="*/ 361507 w 1275907"/>
                    <a:gd name="connsiteY37" fmla="*/ 478465 h 575671"/>
                    <a:gd name="connsiteX38" fmla="*/ 116958 w 1275907"/>
                    <a:gd name="connsiteY38" fmla="*/ 467833 h 575671"/>
                    <a:gd name="connsiteX39" fmla="*/ 85060 w 1275907"/>
                    <a:gd name="connsiteY39" fmla="*/ 457200 h 575671"/>
                    <a:gd name="connsiteX40" fmla="*/ 63795 w 1275907"/>
                    <a:gd name="connsiteY40" fmla="*/ 425302 h 575671"/>
                    <a:gd name="connsiteX41" fmla="*/ 53163 w 1275907"/>
                    <a:gd name="connsiteY41" fmla="*/ 393405 h 575671"/>
                    <a:gd name="connsiteX42" fmla="*/ 42530 w 1275907"/>
                    <a:gd name="connsiteY42" fmla="*/ 329609 h 575671"/>
                    <a:gd name="connsiteX43" fmla="*/ 0 w 1275907"/>
                    <a:gd name="connsiteY43" fmla="*/ 318977 h 575671"/>
                    <a:gd name="connsiteX44" fmla="*/ 53163 w 1275907"/>
                    <a:gd name="connsiteY44" fmla="*/ 265814 h 575671"/>
                    <a:gd name="connsiteX45" fmla="*/ 63795 w 1275907"/>
                    <a:gd name="connsiteY45" fmla="*/ 233916 h 575671"/>
                    <a:gd name="connsiteX46" fmla="*/ 95693 w 1275907"/>
                    <a:gd name="connsiteY46" fmla="*/ 212651 h 575671"/>
                    <a:gd name="connsiteX47" fmla="*/ 85060 w 1275907"/>
                    <a:gd name="connsiteY47" fmla="*/ 180754 h 575671"/>
                    <a:gd name="connsiteX48" fmla="*/ 116958 w 1275907"/>
                    <a:gd name="connsiteY48" fmla="*/ 170121 h 575671"/>
                    <a:gd name="connsiteX49" fmla="*/ 85060 w 1275907"/>
                    <a:gd name="connsiteY49" fmla="*/ 170121 h 57567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</a:cxnLst>
                  <a:rect l="l" t="t" r="r" b="b"/>
                  <a:pathLst>
                    <a:path w="1275907" h="575671">
                      <a:moveTo>
                        <a:pt x="85060" y="170121"/>
                      </a:moveTo>
                      <a:cubicBezTo>
                        <a:pt x="88604" y="166577"/>
                        <a:pt x="121152" y="157391"/>
                        <a:pt x="138223" y="148856"/>
                      </a:cubicBezTo>
                      <a:cubicBezTo>
                        <a:pt x="149653" y="143141"/>
                        <a:pt x="158444" y="132781"/>
                        <a:pt x="170121" y="127591"/>
                      </a:cubicBezTo>
                      <a:cubicBezTo>
                        <a:pt x="190604" y="118487"/>
                        <a:pt x="212651" y="113414"/>
                        <a:pt x="233916" y="106326"/>
                      </a:cubicBezTo>
                      <a:cubicBezTo>
                        <a:pt x="282961" y="89977"/>
                        <a:pt x="254820" y="97892"/>
                        <a:pt x="318977" y="85061"/>
                      </a:cubicBezTo>
                      <a:cubicBezTo>
                        <a:pt x="326065" y="77972"/>
                        <a:pt x="331276" y="68278"/>
                        <a:pt x="340242" y="63795"/>
                      </a:cubicBezTo>
                      <a:cubicBezTo>
                        <a:pt x="394094" y="36869"/>
                        <a:pt x="439589" y="38580"/>
                        <a:pt x="499730" y="31898"/>
                      </a:cubicBezTo>
                      <a:cubicBezTo>
                        <a:pt x="510363" y="28354"/>
                        <a:pt x="520687" y="23696"/>
                        <a:pt x="531628" y="21265"/>
                      </a:cubicBezTo>
                      <a:cubicBezTo>
                        <a:pt x="552673" y="16588"/>
                        <a:pt x="574283" y="14861"/>
                        <a:pt x="595423" y="10633"/>
                      </a:cubicBezTo>
                      <a:cubicBezTo>
                        <a:pt x="609752" y="7767"/>
                        <a:pt x="623776" y="3544"/>
                        <a:pt x="637953" y="0"/>
                      </a:cubicBezTo>
                      <a:cubicBezTo>
                        <a:pt x="668266" y="3368"/>
                        <a:pt x="729920" y="3454"/>
                        <a:pt x="765544" y="21265"/>
                      </a:cubicBezTo>
                      <a:cubicBezTo>
                        <a:pt x="776974" y="26980"/>
                        <a:pt x="786809" y="35442"/>
                        <a:pt x="797442" y="42530"/>
                      </a:cubicBezTo>
                      <a:cubicBezTo>
                        <a:pt x="804530" y="53163"/>
                        <a:pt x="807871" y="67655"/>
                        <a:pt x="818707" y="74428"/>
                      </a:cubicBezTo>
                      <a:cubicBezTo>
                        <a:pt x="837715" y="86308"/>
                        <a:pt x="882502" y="95693"/>
                        <a:pt x="882502" y="95693"/>
                      </a:cubicBezTo>
                      <a:cubicBezTo>
                        <a:pt x="893135" y="102781"/>
                        <a:pt x="902970" y="111243"/>
                        <a:pt x="914400" y="116958"/>
                      </a:cubicBezTo>
                      <a:cubicBezTo>
                        <a:pt x="924425" y="121970"/>
                        <a:pt x="935485" y="124642"/>
                        <a:pt x="946298" y="127591"/>
                      </a:cubicBezTo>
                      <a:cubicBezTo>
                        <a:pt x="974494" y="135281"/>
                        <a:pt x="1003632" y="139614"/>
                        <a:pt x="1031358" y="148856"/>
                      </a:cubicBezTo>
                      <a:lnTo>
                        <a:pt x="1095153" y="170121"/>
                      </a:lnTo>
                      <a:cubicBezTo>
                        <a:pt x="1105786" y="173665"/>
                        <a:pt x="1117026" y="175742"/>
                        <a:pt x="1127051" y="180754"/>
                      </a:cubicBezTo>
                      <a:cubicBezTo>
                        <a:pt x="1141228" y="187842"/>
                        <a:pt x="1155013" y="195775"/>
                        <a:pt x="1169581" y="202019"/>
                      </a:cubicBezTo>
                      <a:cubicBezTo>
                        <a:pt x="1179883" y="206434"/>
                        <a:pt x="1191454" y="207639"/>
                        <a:pt x="1201479" y="212651"/>
                      </a:cubicBezTo>
                      <a:cubicBezTo>
                        <a:pt x="1219963" y="221893"/>
                        <a:pt x="1236921" y="233916"/>
                        <a:pt x="1254642" y="244549"/>
                      </a:cubicBezTo>
                      <a:cubicBezTo>
                        <a:pt x="1258186" y="272902"/>
                        <a:pt x="1260163" y="301496"/>
                        <a:pt x="1265274" y="329609"/>
                      </a:cubicBezTo>
                      <a:cubicBezTo>
                        <a:pt x="1267279" y="340636"/>
                        <a:pt x="1275907" y="350299"/>
                        <a:pt x="1275907" y="361507"/>
                      </a:cubicBezTo>
                      <a:cubicBezTo>
                        <a:pt x="1275907" y="372715"/>
                        <a:pt x="1274026" y="386404"/>
                        <a:pt x="1265274" y="393405"/>
                      </a:cubicBezTo>
                      <a:cubicBezTo>
                        <a:pt x="1253863" y="402534"/>
                        <a:pt x="1236921" y="400493"/>
                        <a:pt x="1222744" y="404037"/>
                      </a:cubicBezTo>
                      <a:cubicBezTo>
                        <a:pt x="1223258" y="407633"/>
                        <a:pt x="1246537" y="491329"/>
                        <a:pt x="1222744" y="510363"/>
                      </a:cubicBezTo>
                      <a:cubicBezTo>
                        <a:pt x="1211333" y="519492"/>
                        <a:pt x="1194211" y="516796"/>
                        <a:pt x="1180214" y="520995"/>
                      </a:cubicBezTo>
                      <a:cubicBezTo>
                        <a:pt x="1158744" y="527436"/>
                        <a:pt x="1116418" y="542261"/>
                        <a:pt x="1116418" y="542261"/>
                      </a:cubicBezTo>
                      <a:cubicBezTo>
                        <a:pt x="1109330" y="552893"/>
                        <a:pt x="1107819" y="572469"/>
                        <a:pt x="1095153" y="574158"/>
                      </a:cubicBezTo>
                      <a:cubicBezTo>
                        <a:pt x="1049348" y="580265"/>
                        <a:pt x="1003069" y="566089"/>
                        <a:pt x="956930" y="563526"/>
                      </a:cubicBezTo>
                      <a:cubicBezTo>
                        <a:pt x="875462" y="559000"/>
                        <a:pt x="793897" y="556437"/>
                        <a:pt x="712381" y="552893"/>
                      </a:cubicBezTo>
                      <a:cubicBezTo>
                        <a:pt x="684946" y="548974"/>
                        <a:pt x="635751" y="546476"/>
                        <a:pt x="606056" y="531628"/>
                      </a:cubicBezTo>
                      <a:cubicBezTo>
                        <a:pt x="523613" y="490406"/>
                        <a:pt x="622433" y="526455"/>
                        <a:pt x="542260" y="499730"/>
                      </a:cubicBezTo>
                      <a:cubicBezTo>
                        <a:pt x="535172" y="489098"/>
                        <a:pt x="531831" y="474606"/>
                        <a:pt x="520995" y="467833"/>
                      </a:cubicBezTo>
                      <a:cubicBezTo>
                        <a:pt x="501987" y="455953"/>
                        <a:pt x="457200" y="446568"/>
                        <a:pt x="457200" y="446568"/>
                      </a:cubicBezTo>
                      <a:lnTo>
                        <a:pt x="393405" y="467833"/>
                      </a:lnTo>
                      <a:lnTo>
                        <a:pt x="361507" y="478465"/>
                      </a:lnTo>
                      <a:cubicBezTo>
                        <a:pt x="279991" y="474921"/>
                        <a:pt x="198311" y="474091"/>
                        <a:pt x="116958" y="467833"/>
                      </a:cubicBezTo>
                      <a:cubicBezTo>
                        <a:pt x="105783" y="466973"/>
                        <a:pt x="93812" y="464202"/>
                        <a:pt x="85060" y="457200"/>
                      </a:cubicBezTo>
                      <a:cubicBezTo>
                        <a:pt x="75081" y="449217"/>
                        <a:pt x="70883" y="435935"/>
                        <a:pt x="63795" y="425302"/>
                      </a:cubicBezTo>
                      <a:cubicBezTo>
                        <a:pt x="60251" y="414670"/>
                        <a:pt x="55594" y="404346"/>
                        <a:pt x="53163" y="393405"/>
                      </a:cubicBezTo>
                      <a:cubicBezTo>
                        <a:pt x="48486" y="372360"/>
                        <a:pt x="55061" y="347152"/>
                        <a:pt x="42530" y="329609"/>
                      </a:cubicBezTo>
                      <a:cubicBezTo>
                        <a:pt x="34036" y="317718"/>
                        <a:pt x="14177" y="322521"/>
                        <a:pt x="0" y="318977"/>
                      </a:cubicBezTo>
                      <a:cubicBezTo>
                        <a:pt x="23922" y="223284"/>
                        <a:pt x="-13291" y="318978"/>
                        <a:pt x="53163" y="265814"/>
                      </a:cubicBezTo>
                      <a:cubicBezTo>
                        <a:pt x="61915" y="258813"/>
                        <a:pt x="56794" y="242668"/>
                        <a:pt x="63795" y="233916"/>
                      </a:cubicBezTo>
                      <a:cubicBezTo>
                        <a:pt x="71778" y="223937"/>
                        <a:pt x="85060" y="219739"/>
                        <a:pt x="95693" y="212651"/>
                      </a:cubicBezTo>
                      <a:cubicBezTo>
                        <a:pt x="92149" y="202019"/>
                        <a:pt x="80048" y="190778"/>
                        <a:pt x="85060" y="180754"/>
                      </a:cubicBezTo>
                      <a:cubicBezTo>
                        <a:pt x="90072" y="170729"/>
                        <a:pt x="107633" y="176338"/>
                        <a:pt x="116958" y="170121"/>
                      </a:cubicBezTo>
                      <a:cubicBezTo>
                        <a:pt x="119907" y="168155"/>
                        <a:pt x="81516" y="173665"/>
                        <a:pt x="85060" y="170121"/>
                      </a:cubicBezTo>
                      <a:close/>
                    </a:path>
                  </a:pathLst>
                </a:custGeom>
                <a:gradFill flip="none" rotWithShape="1">
                  <a:gsLst>
                    <a:gs pos="0">
                      <a:schemeClr val="bg1">
                        <a:lumMod val="95000"/>
                        <a:shade val="30000"/>
                        <a:satMod val="115000"/>
                      </a:schemeClr>
                    </a:gs>
                    <a:gs pos="50000">
                      <a:schemeClr val="bg1">
                        <a:lumMod val="95000"/>
                        <a:shade val="67500"/>
                        <a:satMod val="115000"/>
                      </a:schemeClr>
                    </a:gs>
                    <a:gs pos="100000">
                      <a:schemeClr val="bg1">
                        <a:lumMod val="95000"/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38100">
                  <a:solidFill>
                    <a:schemeClr val="tx1"/>
                  </a:solidFill>
                  <a:prstDash val="solid"/>
                </a:ln>
                <a:effectLst/>
                <a:scene3d>
                  <a:camera prst="orthographicFront">
                    <a:rot lat="0" lon="0" rev="0"/>
                  </a:camera>
                  <a:lightRig rig="chilly" dir="t">
                    <a:rot lat="0" lon="0" rev="18480000"/>
                  </a:lightRig>
                </a:scene3d>
                <a:sp3d prstMaterial="clear">
                  <a:bevelT h="635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2" name="Freihandform 31"/>
                <p:cNvSpPr/>
                <p:nvPr/>
              </p:nvSpPr>
              <p:spPr>
                <a:xfrm rot="21365329">
                  <a:off x="6661746" y="5855241"/>
                  <a:ext cx="830577" cy="309342"/>
                </a:xfrm>
                <a:custGeom>
                  <a:avLst/>
                  <a:gdLst>
                    <a:gd name="connsiteX0" fmla="*/ 0 w 1405953"/>
                    <a:gd name="connsiteY0" fmla="*/ 128838 h 543508"/>
                    <a:gd name="connsiteX1" fmla="*/ 31898 w 1405953"/>
                    <a:gd name="connsiteY1" fmla="*/ 182001 h 543508"/>
                    <a:gd name="connsiteX2" fmla="*/ 95693 w 1405953"/>
                    <a:gd name="connsiteY2" fmla="*/ 213898 h 543508"/>
                    <a:gd name="connsiteX3" fmla="*/ 148856 w 1405953"/>
                    <a:gd name="connsiteY3" fmla="*/ 256428 h 543508"/>
                    <a:gd name="connsiteX4" fmla="*/ 170121 w 1405953"/>
                    <a:gd name="connsiteY4" fmla="*/ 277694 h 543508"/>
                    <a:gd name="connsiteX5" fmla="*/ 233917 w 1405953"/>
                    <a:gd name="connsiteY5" fmla="*/ 320224 h 543508"/>
                    <a:gd name="connsiteX6" fmla="*/ 287079 w 1405953"/>
                    <a:gd name="connsiteY6" fmla="*/ 362754 h 543508"/>
                    <a:gd name="connsiteX7" fmla="*/ 318977 w 1405953"/>
                    <a:gd name="connsiteY7" fmla="*/ 394652 h 543508"/>
                    <a:gd name="connsiteX8" fmla="*/ 340242 w 1405953"/>
                    <a:gd name="connsiteY8" fmla="*/ 426549 h 543508"/>
                    <a:gd name="connsiteX9" fmla="*/ 372140 w 1405953"/>
                    <a:gd name="connsiteY9" fmla="*/ 437182 h 543508"/>
                    <a:gd name="connsiteX10" fmla="*/ 404037 w 1405953"/>
                    <a:gd name="connsiteY10" fmla="*/ 458447 h 543508"/>
                    <a:gd name="connsiteX11" fmla="*/ 457200 w 1405953"/>
                    <a:gd name="connsiteY11" fmla="*/ 500977 h 543508"/>
                    <a:gd name="connsiteX12" fmla="*/ 520996 w 1405953"/>
                    <a:gd name="connsiteY12" fmla="*/ 522242 h 543508"/>
                    <a:gd name="connsiteX13" fmla="*/ 552893 w 1405953"/>
                    <a:gd name="connsiteY13" fmla="*/ 532875 h 543508"/>
                    <a:gd name="connsiteX14" fmla="*/ 584791 w 1405953"/>
                    <a:gd name="connsiteY14" fmla="*/ 543508 h 543508"/>
                    <a:gd name="connsiteX15" fmla="*/ 754912 w 1405953"/>
                    <a:gd name="connsiteY15" fmla="*/ 532875 h 543508"/>
                    <a:gd name="connsiteX16" fmla="*/ 786810 w 1405953"/>
                    <a:gd name="connsiteY16" fmla="*/ 522242 h 543508"/>
                    <a:gd name="connsiteX17" fmla="*/ 839972 w 1405953"/>
                    <a:gd name="connsiteY17" fmla="*/ 511610 h 543508"/>
                    <a:gd name="connsiteX18" fmla="*/ 871870 w 1405953"/>
                    <a:gd name="connsiteY18" fmla="*/ 490345 h 543508"/>
                    <a:gd name="connsiteX19" fmla="*/ 893135 w 1405953"/>
                    <a:gd name="connsiteY19" fmla="*/ 458447 h 543508"/>
                    <a:gd name="connsiteX20" fmla="*/ 956930 w 1405953"/>
                    <a:gd name="connsiteY20" fmla="*/ 437182 h 543508"/>
                    <a:gd name="connsiteX21" fmla="*/ 1020726 w 1405953"/>
                    <a:gd name="connsiteY21" fmla="*/ 415917 h 543508"/>
                    <a:gd name="connsiteX22" fmla="*/ 1052624 w 1405953"/>
                    <a:gd name="connsiteY22" fmla="*/ 405284 h 543508"/>
                    <a:gd name="connsiteX23" fmla="*/ 1116419 w 1405953"/>
                    <a:gd name="connsiteY23" fmla="*/ 362754 h 543508"/>
                    <a:gd name="connsiteX24" fmla="*/ 1137684 w 1405953"/>
                    <a:gd name="connsiteY24" fmla="*/ 330856 h 543508"/>
                    <a:gd name="connsiteX25" fmla="*/ 1169582 w 1405953"/>
                    <a:gd name="connsiteY25" fmla="*/ 320224 h 543508"/>
                    <a:gd name="connsiteX26" fmla="*/ 1201479 w 1405953"/>
                    <a:gd name="connsiteY26" fmla="*/ 298959 h 543508"/>
                    <a:gd name="connsiteX27" fmla="*/ 1403498 w 1405953"/>
                    <a:gd name="connsiteY27" fmla="*/ 298959 h 543508"/>
                    <a:gd name="connsiteX28" fmla="*/ 1371600 w 1405953"/>
                    <a:gd name="connsiteY28" fmla="*/ 277694 h 543508"/>
                    <a:gd name="connsiteX29" fmla="*/ 1350335 w 1405953"/>
                    <a:gd name="connsiteY29" fmla="*/ 256428 h 543508"/>
                    <a:gd name="connsiteX30" fmla="*/ 1286540 w 1405953"/>
                    <a:gd name="connsiteY30" fmla="*/ 224531 h 543508"/>
                    <a:gd name="connsiteX31" fmla="*/ 1244010 w 1405953"/>
                    <a:gd name="connsiteY31" fmla="*/ 182001 h 543508"/>
                    <a:gd name="connsiteX32" fmla="*/ 1201479 w 1405953"/>
                    <a:gd name="connsiteY32" fmla="*/ 128838 h 543508"/>
                    <a:gd name="connsiteX33" fmla="*/ 1137684 w 1405953"/>
                    <a:gd name="connsiteY33" fmla="*/ 107573 h 543508"/>
                    <a:gd name="connsiteX34" fmla="*/ 1105786 w 1405953"/>
                    <a:gd name="connsiteY34" fmla="*/ 86308 h 543508"/>
                    <a:gd name="connsiteX35" fmla="*/ 1073889 w 1405953"/>
                    <a:gd name="connsiteY35" fmla="*/ 75675 h 543508"/>
                    <a:gd name="connsiteX36" fmla="*/ 946298 w 1405953"/>
                    <a:gd name="connsiteY36" fmla="*/ 54410 h 543508"/>
                    <a:gd name="connsiteX37" fmla="*/ 893135 w 1405953"/>
                    <a:gd name="connsiteY37" fmla="*/ 43777 h 543508"/>
                    <a:gd name="connsiteX38" fmla="*/ 744279 w 1405953"/>
                    <a:gd name="connsiteY38" fmla="*/ 22512 h 543508"/>
                    <a:gd name="connsiteX39" fmla="*/ 712382 w 1405953"/>
                    <a:gd name="connsiteY39" fmla="*/ 11880 h 543508"/>
                    <a:gd name="connsiteX40" fmla="*/ 318977 w 1405953"/>
                    <a:gd name="connsiteY40" fmla="*/ 11880 h 543508"/>
                    <a:gd name="connsiteX41" fmla="*/ 244549 w 1405953"/>
                    <a:gd name="connsiteY41" fmla="*/ 33145 h 543508"/>
                    <a:gd name="connsiteX42" fmla="*/ 138224 w 1405953"/>
                    <a:gd name="connsiteY42" fmla="*/ 65042 h 543508"/>
                    <a:gd name="connsiteX43" fmla="*/ 106326 w 1405953"/>
                    <a:gd name="connsiteY43" fmla="*/ 75675 h 543508"/>
                    <a:gd name="connsiteX44" fmla="*/ 42530 w 1405953"/>
                    <a:gd name="connsiteY44" fmla="*/ 118205 h 543508"/>
                    <a:gd name="connsiteX45" fmla="*/ 10633 w 1405953"/>
                    <a:gd name="connsiteY45" fmla="*/ 139470 h 543508"/>
                    <a:gd name="connsiteX46" fmla="*/ 0 w 1405953"/>
                    <a:gd name="connsiteY46" fmla="*/ 128838 h 543508"/>
                    <a:gd name="connsiteX0" fmla="*/ 0 w 1684485"/>
                    <a:gd name="connsiteY0" fmla="*/ 142220 h 543508"/>
                    <a:gd name="connsiteX1" fmla="*/ 310430 w 1684485"/>
                    <a:gd name="connsiteY1" fmla="*/ 182001 h 543508"/>
                    <a:gd name="connsiteX2" fmla="*/ 374225 w 1684485"/>
                    <a:gd name="connsiteY2" fmla="*/ 213898 h 543508"/>
                    <a:gd name="connsiteX3" fmla="*/ 427388 w 1684485"/>
                    <a:gd name="connsiteY3" fmla="*/ 256428 h 543508"/>
                    <a:gd name="connsiteX4" fmla="*/ 448653 w 1684485"/>
                    <a:gd name="connsiteY4" fmla="*/ 277694 h 543508"/>
                    <a:gd name="connsiteX5" fmla="*/ 512449 w 1684485"/>
                    <a:gd name="connsiteY5" fmla="*/ 320224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  <a:gd name="connsiteX0" fmla="*/ 0 w 1684485"/>
                    <a:gd name="connsiteY0" fmla="*/ 142220 h 543508"/>
                    <a:gd name="connsiteX1" fmla="*/ 171164 w 1684485"/>
                    <a:gd name="connsiteY1" fmla="*/ 222145 h 543508"/>
                    <a:gd name="connsiteX2" fmla="*/ 374225 w 1684485"/>
                    <a:gd name="connsiteY2" fmla="*/ 213898 h 543508"/>
                    <a:gd name="connsiteX3" fmla="*/ 427388 w 1684485"/>
                    <a:gd name="connsiteY3" fmla="*/ 256428 h 543508"/>
                    <a:gd name="connsiteX4" fmla="*/ 448653 w 1684485"/>
                    <a:gd name="connsiteY4" fmla="*/ 277694 h 543508"/>
                    <a:gd name="connsiteX5" fmla="*/ 512449 w 1684485"/>
                    <a:gd name="connsiteY5" fmla="*/ 320224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  <a:gd name="connsiteX0" fmla="*/ 0 w 1684485"/>
                    <a:gd name="connsiteY0" fmla="*/ 142220 h 543508"/>
                    <a:gd name="connsiteX1" fmla="*/ 171164 w 1684485"/>
                    <a:gd name="connsiteY1" fmla="*/ 222145 h 543508"/>
                    <a:gd name="connsiteX2" fmla="*/ 310922 w 1684485"/>
                    <a:gd name="connsiteY2" fmla="*/ 267423 h 543508"/>
                    <a:gd name="connsiteX3" fmla="*/ 427388 w 1684485"/>
                    <a:gd name="connsiteY3" fmla="*/ 256428 h 543508"/>
                    <a:gd name="connsiteX4" fmla="*/ 448653 w 1684485"/>
                    <a:gd name="connsiteY4" fmla="*/ 277694 h 543508"/>
                    <a:gd name="connsiteX5" fmla="*/ 512449 w 1684485"/>
                    <a:gd name="connsiteY5" fmla="*/ 320224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  <a:gd name="connsiteX0" fmla="*/ 0 w 1684485"/>
                    <a:gd name="connsiteY0" fmla="*/ 142220 h 543508"/>
                    <a:gd name="connsiteX1" fmla="*/ 171164 w 1684485"/>
                    <a:gd name="connsiteY1" fmla="*/ 222145 h 543508"/>
                    <a:gd name="connsiteX2" fmla="*/ 310922 w 1684485"/>
                    <a:gd name="connsiteY2" fmla="*/ 267423 h 543508"/>
                    <a:gd name="connsiteX3" fmla="*/ 427388 w 1684485"/>
                    <a:gd name="connsiteY3" fmla="*/ 256428 h 543508"/>
                    <a:gd name="connsiteX4" fmla="*/ 410672 w 1684485"/>
                    <a:gd name="connsiteY4" fmla="*/ 317836 h 543508"/>
                    <a:gd name="connsiteX5" fmla="*/ 512449 w 1684485"/>
                    <a:gd name="connsiteY5" fmla="*/ 320224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  <a:gd name="connsiteX0" fmla="*/ 0 w 1684485"/>
                    <a:gd name="connsiteY0" fmla="*/ 142220 h 543508"/>
                    <a:gd name="connsiteX1" fmla="*/ 171164 w 1684485"/>
                    <a:gd name="connsiteY1" fmla="*/ 222145 h 543508"/>
                    <a:gd name="connsiteX2" fmla="*/ 310922 w 1684485"/>
                    <a:gd name="connsiteY2" fmla="*/ 267423 h 543508"/>
                    <a:gd name="connsiteX3" fmla="*/ 376746 w 1684485"/>
                    <a:gd name="connsiteY3" fmla="*/ 323335 h 543508"/>
                    <a:gd name="connsiteX4" fmla="*/ 410672 w 1684485"/>
                    <a:gd name="connsiteY4" fmla="*/ 317836 h 543508"/>
                    <a:gd name="connsiteX5" fmla="*/ 512449 w 1684485"/>
                    <a:gd name="connsiteY5" fmla="*/ 320224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  <a:gd name="connsiteX0" fmla="*/ 0 w 1684485"/>
                    <a:gd name="connsiteY0" fmla="*/ 142220 h 543508"/>
                    <a:gd name="connsiteX1" fmla="*/ 171164 w 1684485"/>
                    <a:gd name="connsiteY1" fmla="*/ 222145 h 543508"/>
                    <a:gd name="connsiteX2" fmla="*/ 310922 w 1684485"/>
                    <a:gd name="connsiteY2" fmla="*/ 267423 h 543508"/>
                    <a:gd name="connsiteX3" fmla="*/ 376746 w 1684485"/>
                    <a:gd name="connsiteY3" fmla="*/ 323335 h 543508"/>
                    <a:gd name="connsiteX4" fmla="*/ 410672 w 1684485"/>
                    <a:gd name="connsiteY4" fmla="*/ 317836 h 543508"/>
                    <a:gd name="connsiteX5" fmla="*/ 449146 w 1684485"/>
                    <a:gd name="connsiteY5" fmla="*/ 373750 h 543508"/>
                    <a:gd name="connsiteX6" fmla="*/ 565611 w 1684485"/>
                    <a:gd name="connsiteY6" fmla="*/ 362754 h 543508"/>
                    <a:gd name="connsiteX7" fmla="*/ 597509 w 1684485"/>
                    <a:gd name="connsiteY7" fmla="*/ 394652 h 543508"/>
                    <a:gd name="connsiteX8" fmla="*/ 618774 w 1684485"/>
                    <a:gd name="connsiteY8" fmla="*/ 426549 h 543508"/>
                    <a:gd name="connsiteX9" fmla="*/ 650672 w 1684485"/>
                    <a:gd name="connsiteY9" fmla="*/ 437182 h 543508"/>
                    <a:gd name="connsiteX10" fmla="*/ 682569 w 1684485"/>
                    <a:gd name="connsiteY10" fmla="*/ 458447 h 543508"/>
                    <a:gd name="connsiteX11" fmla="*/ 735732 w 1684485"/>
                    <a:gd name="connsiteY11" fmla="*/ 500977 h 543508"/>
                    <a:gd name="connsiteX12" fmla="*/ 799528 w 1684485"/>
                    <a:gd name="connsiteY12" fmla="*/ 522242 h 543508"/>
                    <a:gd name="connsiteX13" fmla="*/ 831425 w 1684485"/>
                    <a:gd name="connsiteY13" fmla="*/ 532875 h 543508"/>
                    <a:gd name="connsiteX14" fmla="*/ 863323 w 1684485"/>
                    <a:gd name="connsiteY14" fmla="*/ 543508 h 543508"/>
                    <a:gd name="connsiteX15" fmla="*/ 1033444 w 1684485"/>
                    <a:gd name="connsiteY15" fmla="*/ 532875 h 543508"/>
                    <a:gd name="connsiteX16" fmla="*/ 1065342 w 1684485"/>
                    <a:gd name="connsiteY16" fmla="*/ 522242 h 543508"/>
                    <a:gd name="connsiteX17" fmla="*/ 1118504 w 1684485"/>
                    <a:gd name="connsiteY17" fmla="*/ 511610 h 543508"/>
                    <a:gd name="connsiteX18" fmla="*/ 1150402 w 1684485"/>
                    <a:gd name="connsiteY18" fmla="*/ 490345 h 543508"/>
                    <a:gd name="connsiteX19" fmla="*/ 1171667 w 1684485"/>
                    <a:gd name="connsiteY19" fmla="*/ 458447 h 543508"/>
                    <a:gd name="connsiteX20" fmla="*/ 1235462 w 1684485"/>
                    <a:gd name="connsiteY20" fmla="*/ 437182 h 543508"/>
                    <a:gd name="connsiteX21" fmla="*/ 1299258 w 1684485"/>
                    <a:gd name="connsiteY21" fmla="*/ 415917 h 543508"/>
                    <a:gd name="connsiteX22" fmla="*/ 1331156 w 1684485"/>
                    <a:gd name="connsiteY22" fmla="*/ 405284 h 543508"/>
                    <a:gd name="connsiteX23" fmla="*/ 1394951 w 1684485"/>
                    <a:gd name="connsiteY23" fmla="*/ 362754 h 543508"/>
                    <a:gd name="connsiteX24" fmla="*/ 1416216 w 1684485"/>
                    <a:gd name="connsiteY24" fmla="*/ 330856 h 543508"/>
                    <a:gd name="connsiteX25" fmla="*/ 1448114 w 1684485"/>
                    <a:gd name="connsiteY25" fmla="*/ 320224 h 543508"/>
                    <a:gd name="connsiteX26" fmla="*/ 1480011 w 1684485"/>
                    <a:gd name="connsiteY26" fmla="*/ 298959 h 543508"/>
                    <a:gd name="connsiteX27" fmla="*/ 1682030 w 1684485"/>
                    <a:gd name="connsiteY27" fmla="*/ 298959 h 543508"/>
                    <a:gd name="connsiteX28" fmla="*/ 1650132 w 1684485"/>
                    <a:gd name="connsiteY28" fmla="*/ 277694 h 543508"/>
                    <a:gd name="connsiteX29" fmla="*/ 1628867 w 1684485"/>
                    <a:gd name="connsiteY29" fmla="*/ 256428 h 543508"/>
                    <a:gd name="connsiteX30" fmla="*/ 1565072 w 1684485"/>
                    <a:gd name="connsiteY30" fmla="*/ 224531 h 543508"/>
                    <a:gd name="connsiteX31" fmla="*/ 1522542 w 1684485"/>
                    <a:gd name="connsiteY31" fmla="*/ 182001 h 543508"/>
                    <a:gd name="connsiteX32" fmla="*/ 1480011 w 1684485"/>
                    <a:gd name="connsiteY32" fmla="*/ 128838 h 543508"/>
                    <a:gd name="connsiteX33" fmla="*/ 1416216 w 1684485"/>
                    <a:gd name="connsiteY33" fmla="*/ 107573 h 543508"/>
                    <a:gd name="connsiteX34" fmla="*/ 1384318 w 1684485"/>
                    <a:gd name="connsiteY34" fmla="*/ 86308 h 543508"/>
                    <a:gd name="connsiteX35" fmla="*/ 1352421 w 1684485"/>
                    <a:gd name="connsiteY35" fmla="*/ 75675 h 543508"/>
                    <a:gd name="connsiteX36" fmla="*/ 1224830 w 1684485"/>
                    <a:gd name="connsiteY36" fmla="*/ 54410 h 543508"/>
                    <a:gd name="connsiteX37" fmla="*/ 1171667 w 1684485"/>
                    <a:gd name="connsiteY37" fmla="*/ 43777 h 543508"/>
                    <a:gd name="connsiteX38" fmla="*/ 1022811 w 1684485"/>
                    <a:gd name="connsiteY38" fmla="*/ 22512 h 543508"/>
                    <a:gd name="connsiteX39" fmla="*/ 990914 w 1684485"/>
                    <a:gd name="connsiteY39" fmla="*/ 11880 h 543508"/>
                    <a:gd name="connsiteX40" fmla="*/ 597509 w 1684485"/>
                    <a:gd name="connsiteY40" fmla="*/ 11880 h 543508"/>
                    <a:gd name="connsiteX41" fmla="*/ 523081 w 1684485"/>
                    <a:gd name="connsiteY41" fmla="*/ 33145 h 543508"/>
                    <a:gd name="connsiteX42" fmla="*/ 416756 w 1684485"/>
                    <a:gd name="connsiteY42" fmla="*/ 65042 h 543508"/>
                    <a:gd name="connsiteX43" fmla="*/ 384858 w 1684485"/>
                    <a:gd name="connsiteY43" fmla="*/ 75675 h 543508"/>
                    <a:gd name="connsiteX44" fmla="*/ 321062 w 1684485"/>
                    <a:gd name="connsiteY44" fmla="*/ 118205 h 543508"/>
                    <a:gd name="connsiteX45" fmla="*/ 289165 w 1684485"/>
                    <a:gd name="connsiteY45" fmla="*/ 139470 h 543508"/>
                    <a:gd name="connsiteX46" fmla="*/ 0 w 1684485"/>
                    <a:gd name="connsiteY46" fmla="*/ 142220 h 54350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</a:cxnLst>
                  <a:rect l="l" t="t" r="r" b="b"/>
                  <a:pathLst>
                    <a:path w="1684485" h="543508">
                      <a:moveTo>
                        <a:pt x="0" y="142220"/>
                      </a:moveTo>
                      <a:cubicBezTo>
                        <a:pt x="10633" y="159941"/>
                        <a:pt x="119344" y="201278"/>
                        <a:pt x="171164" y="222145"/>
                      </a:cubicBezTo>
                      <a:cubicBezTo>
                        <a:pt x="222984" y="243012"/>
                        <a:pt x="288594" y="259981"/>
                        <a:pt x="310922" y="267423"/>
                      </a:cubicBezTo>
                      <a:cubicBezTo>
                        <a:pt x="353277" y="330956"/>
                        <a:pt x="360121" y="314933"/>
                        <a:pt x="376746" y="323335"/>
                      </a:cubicBezTo>
                      <a:cubicBezTo>
                        <a:pt x="393371" y="331737"/>
                        <a:pt x="398605" y="309434"/>
                        <a:pt x="410672" y="317836"/>
                      </a:cubicBezTo>
                      <a:cubicBezTo>
                        <a:pt x="422739" y="326239"/>
                        <a:pt x="423323" y="366264"/>
                        <a:pt x="449146" y="373750"/>
                      </a:cubicBezTo>
                      <a:cubicBezTo>
                        <a:pt x="474969" y="381236"/>
                        <a:pt x="540884" y="359270"/>
                        <a:pt x="565611" y="362754"/>
                      </a:cubicBezTo>
                      <a:cubicBezTo>
                        <a:pt x="590338" y="366238"/>
                        <a:pt x="587883" y="383100"/>
                        <a:pt x="597509" y="394652"/>
                      </a:cubicBezTo>
                      <a:cubicBezTo>
                        <a:pt x="605690" y="404469"/>
                        <a:pt x="608796" y="418566"/>
                        <a:pt x="618774" y="426549"/>
                      </a:cubicBezTo>
                      <a:cubicBezTo>
                        <a:pt x="627526" y="433550"/>
                        <a:pt x="640647" y="432170"/>
                        <a:pt x="650672" y="437182"/>
                      </a:cubicBezTo>
                      <a:cubicBezTo>
                        <a:pt x="662101" y="442897"/>
                        <a:pt x="672591" y="450464"/>
                        <a:pt x="682569" y="458447"/>
                      </a:cubicBezTo>
                      <a:cubicBezTo>
                        <a:pt x="710182" y="480537"/>
                        <a:pt x="698921" y="484617"/>
                        <a:pt x="735732" y="500977"/>
                      </a:cubicBezTo>
                      <a:cubicBezTo>
                        <a:pt x="756216" y="510081"/>
                        <a:pt x="778263" y="515153"/>
                        <a:pt x="799528" y="522242"/>
                      </a:cubicBezTo>
                      <a:lnTo>
                        <a:pt x="831425" y="532875"/>
                      </a:lnTo>
                      <a:lnTo>
                        <a:pt x="863323" y="543508"/>
                      </a:lnTo>
                      <a:cubicBezTo>
                        <a:pt x="920030" y="539964"/>
                        <a:pt x="976939" y="538823"/>
                        <a:pt x="1033444" y="532875"/>
                      </a:cubicBezTo>
                      <a:cubicBezTo>
                        <a:pt x="1044590" y="531702"/>
                        <a:pt x="1054469" y="524960"/>
                        <a:pt x="1065342" y="522242"/>
                      </a:cubicBezTo>
                      <a:cubicBezTo>
                        <a:pt x="1082874" y="517859"/>
                        <a:pt x="1100783" y="515154"/>
                        <a:pt x="1118504" y="511610"/>
                      </a:cubicBezTo>
                      <a:cubicBezTo>
                        <a:pt x="1129137" y="504522"/>
                        <a:pt x="1141366" y="499381"/>
                        <a:pt x="1150402" y="490345"/>
                      </a:cubicBezTo>
                      <a:cubicBezTo>
                        <a:pt x="1159438" y="481309"/>
                        <a:pt x="1160831" y="465220"/>
                        <a:pt x="1171667" y="458447"/>
                      </a:cubicBezTo>
                      <a:cubicBezTo>
                        <a:pt x="1190675" y="446567"/>
                        <a:pt x="1214197" y="444270"/>
                        <a:pt x="1235462" y="437182"/>
                      </a:cubicBezTo>
                      <a:lnTo>
                        <a:pt x="1299258" y="415917"/>
                      </a:lnTo>
                      <a:cubicBezTo>
                        <a:pt x="1309891" y="412373"/>
                        <a:pt x="1321831" y="411501"/>
                        <a:pt x="1331156" y="405284"/>
                      </a:cubicBezTo>
                      <a:lnTo>
                        <a:pt x="1394951" y="362754"/>
                      </a:lnTo>
                      <a:cubicBezTo>
                        <a:pt x="1402039" y="352121"/>
                        <a:pt x="1406237" y="338839"/>
                        <a:pt x="1416216" y="330856"/>
                      </a:cubicBezTo>
                      <a:cubicBezTo>
                        <a:pt x="1424968" y="323855"/>
                        <a:pt x="1438089" y="325236"/>
                        <a:pt x="1448114" y="320224"/>
                      </a:cubicBezTo>
                      <a:cubicBezTo>
                        <a:pt x="1459544" y="314509"/>
                        <a:pt x="1469379" y="306047"/>
                        <a:pt x="1480011" y="298959"/>
                      </a:cubicBezTo>
                      <a:cubicBezTo>
                        <a:pt x="1535257" y="305097"/>
                        <a:pt x="1627947" y="322137"/>
                        <a:pt x="1682030" y="298959"/>
                      </a:cubicBezTo>
                      <a:cubicBezTo>
                        <a:pt x="1693776" y="293925"/>
                        <a:pt x="1660111" y="285677"/>
                        <a:pt x="1650132" y="277694"/>
                      </a:cubicBezTo>
                      <a:cubicBezTo>
                        <a:pt x="1642304" y="271432"/>
                        <a:pt x="1636695" y="262690"/>
                        <a:pt x="1628867" y="256428"/>
                      </a:cubicBezTo>
                      <a:cubicBezTo>
                        <a:pt x="1599423" y="232873"/>
                        <a:pt x="1598761" y="235760"/>
                        <a:pt x="1565072" y="224531"/>
                      </a:cubicBezTo>
                      <a:cubicBezTo>
                        <a:pt x="1536717" y="139468"/>
                        <a:pt x="1579249" y="238708"/>
                        <a:pt x="1522542" y="182001"/>
                      </a:cubicBezTo>
                      <a:cubicBezTo>
                        <a:pt x="1469505" y="128964"/>
                        <a:pt x="1564974" y="166599"/>
                        <a:pt x="1480011" y="128838"/>
                      </a:cubicBezTo>
                      <a:cubicBezTo>
                        <a:pt x="1459528" y="119734"/>
                        <a:pt x="1416216" y="107573"/>
                        <a:pt x="1416216" y="107573"/>
                      </a:cubicBezTo>
                      <a:cubicBezTo>
                        <a:pt x="1405583" y="100485"/>
                        <a:pt x="1395748" y="92023"/>
                        <a:pt x="1384318" y="86308"/>
                      </a:cubicBezTo>
                      <a:cubicBezTo>
                        <a:pt x="1374294" y="81296"/>
                        <a:pt x="1363197" y="78754"/>
                        <a:pt x="1352421" y="75675"/>
                      </a:cubicBezTo>
                      <a:cubicBezTo>
                        <a:pt x="1290058" y="57856"/>
                        <a:pt x="1308966" y="67354"/>
                        <a:pt x="1224830" y="54410"/>
                      </a:cubicBezTo>
                      <a:cubicBezTo>
                        <a:pt x="1206968" y="51662"/>
                        <a:pt x="1189518" y="46596"/>
                        <a:pt x="1171667" y="43777"/>
                      </a:cubicBezTo>
                      <a:cubicBezTo>
                        <a:pt x="1122158" y="35960"/>
                        <a:pt x="1022811" y="22512"/>
                        <a:pt x="1022811" y="22512"/>
                      </a:cubicBezTo>
                      <a:cubicBezTo>
                        <a:pt x="1012179" y="18968"/>
                        <a:pt x="1001969" y="13722"/>
                        <a:pt x="990914" y="11880"/>
                      </a:cubicBezTo>
                      <a:cubicBezTo>
                        <a:pt x="849884" y="-11625"/>
                        <a:pt x="762208" y="5998"/>
                        <a:pt x="597509" y="11880"/>
                      </a:cubicBezTo>
                      <a:cubicBezTo>
                        <a:pt x="464555" y="45117"/>
                        <a:pt x="629856" y="2638"/>
                        <a:pt x="523081" y="33145"/>
                      </a:cubicBezTo>
                      <a:cubicBezTo>
                        <a:pt x="410594" y="65284"/>
                        <a:pt x="568367" y="14505"/>
                        <a:pt x="416756" y="65042"/>
                      </a:cubicBezTo>
                      <a:cubicBezTo>
                        <a:pt x="406123" y="68586"/>
                        <a:pt x="394184" y="69458"/>
                        <a:pt x="384858" y="75675"/>
                      </a:cubicBezTo>
                      <a:lnTo>
                        <a:pt x="321062" y="118205"/>
                      </a:lnTo>
                      <a:cubicBezTo>
                        <a:pt x="310430" y="125293"/>
                        <a:pt x="300594" y="133755"/>
                        <a:pt x="289165" y="139470"/>
                      </a:cubicBezTo>
                      <a:lnTo>
                        <a:pt x="0" y="142220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7" name="Textfeld 36"/>
                <p:cNvSpPr txBox="1"/>
                <p:nvPr/>
              </p:nvSpPr>
              <p:spPr>
                <a:xfrm>
                  <a:off x="7005278" y="6211805"/>
                  <a:ext cx="4515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b="1" dirty="0" err="1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Ki</a:t>
                  </a:r>
                  <a:endParaRPr lang="de-DE" sz="14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Textfeld 37"/>
                <p:cNvSpPr txBox="1"/>
                <p:nvPr/>
              </p:nvSpPr>
              <p:spPr>
                <a:xfrm>
                  <a:off x="6885528" y="5843229"/>
                  <a:ext cx="41389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400" b="1" dirty="0" err="1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p</a:t>
                  </a:r>
                  <a:endParaRPr lang="de-DE" sz="14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feld 41"/>
                <p:cNvSpPr txBox="1"/>
                <p:nvPr/>
              </p:nvSpPr>
              <p:spPr>
                <a:xfrm>
                  <a:off x="6090878" y="5953503"/>
                  <a:ext cx="364202" cy="307777"/>
                </a:xfrm>
                <a:prstGeom prst="rect">
                  <a:avLst/>
                </a:prstGeom>
                <a:noFill/>
                <a:effectLst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4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t</a:t>
                  </a:r>
                </a:p>
              </p:txBody>
            </p:sp>
            <p:sp>
              <p:nvSpPr>
                <p:cNvPr id="30" name="Freihandform 29"/>
                <p:cNvSpPr/>
                <p:nvPr/>
              </p:nvSpPr>
              <p:spPr>
                <a:xfrm rot="21346498">
                  <a:off x="5569793" y="6021690"/>
                  <a:ext cx="295314" cy="361225"/>
                </a:xfrm>
                <a:custGeom>
                  <a:avLst/>
                  <a:gdLst>
                    <a:gd name="connsiteX0" fmla="*/ 21265 w 663783"/>
                    <a:gd name="connsiteY0" fmla="*/ 563525 h 563525"/>
                    <a:gd name="connsiteX1" fmla="*/ 106326 w 663783"/>
                    <a:gd name="connsiteY1" fmla="*/ 552893 h 563525"/>
                    <a:gd name="connsiteX2" fmla="*/ 127591 w 663783"/>
                    <a:gd name="connsiteY2" fmla="*/ 520995 h 563525"/>
                    <a:gd name="connsiteX3" fmla="*/ 159489 w 663783"/>
                    <a:gd name="connsiteY3" fmla="*/ 499730 h 563525"/>
                    <a:gd name="connsiteX4" fmla="*/ 202019 w 663783"/>
                    <a:gd name="connsiteY4" fmla="*/ 489098 h 563525"/>
                    <a:gd name="connsiteX5" fmla="*/ 265814 w 663783"/>
                    <a:gd name="connsiteY5" fmla="*/ 467832 h 563525"/>
                    <a:gd name="connsiteX6" fmla="*/ 318977 w 663783"/>
                    <a:gd name="connsiteY6" fmla="*/ 414670 h 563525"/>
                    <a:gd name="connsiteX7" fmla="*/ 350875 w 663783"/>
                    <a:gd name="connsiteY7" fmla="*/ 382772 h 563525"/>
                    <a:gd name="connsiteX8" fmla="*/ 372140 w 663783"/>
                    <a:gd name="connsiteY8" fmla="*/ 350874 h 563525"/>
                    <a:gd name="connsiteX9" fmla="*/ 404037 w 663783"/>
                    <a:gd name="connsiteY9" fmla="*/ 340242 h 563525"/>
                    <a:gd name="connsiteX10" fmla="*/ 467833 w 663783"/>
                    <a:gd name="connsiteY10" fmla="*/ 297712 h 563525"/>
                    <a:gd name="connsiteX11" fmla="*/ 510363 w 663783"/>
                    <a:gd name="connsiteY11" fmla="*/ 233916 h 563525"/>
                    <a:gd name="connsiteX12" fmla="*/ 520996 w 663783"/>
                    <a:gd name="connsiteY12" fmla="*/ 202018 h 563525"/>
                    <a:gd name="connsiteX13" fmla="*/ 552893 w 663783"/>
                    <a:gd name="connsiteY13" fmla="*/ 180753 h 563525"/>
                    <a:gd name="connsiteX14" fmla="*/ 574158 w 663783"/>
                    <a:gd name="connsiteY14" fmla="*/ 148856 h 563525"/>
                    <a:gd name="connsiteX15" fmla="*/ 595423 w 663783"/>
                    <a:gd name="connsiteY15" fmla="*/ 85060 h 563525"/>
                    <a:gd name="connsiteX16" fmla="*/ 648586 w 663783"/>
                    <a:gd name="connsiteY16" fmla="*/ 42530 h 563525"/>
                    <a:gd name="connsiteX17" fmla="*/ 659219 w 663783"/>
                    <a:gd name="connsiteY17" fmla="*/ 0 h 563525"/>
                    <a:gd name="connsiteX18" fmla="*/ 563526 w 663783"/>
                    <a:gd name="connsiteY18" fmla="*/ 31898 h 563525"/>
                    <a:gd name="connsiteX19" fmla="*/ 425302 w 663783"/>
                    <a:gd name="connsiteY19" fmla="*/ 53163 h 563525"/>
                    <a:gd name="connsiteX20" fmla="*/ 297712 w 663783"/>
                    <a:gd name="connsiteY20" fmla="*/ 74428 h 563525"/>
                    <a:gd name="connsiteX21" fmla="*/ 212651 w 663783"/>
                    <a:gd name="connsiteY21" fmla="*/ 85060 h 563525"/>
                    <a:gd name="connsiteX22" fmla="*/ 180754 w 663783"/>
                    <a:gd name="connsiteY22" fmla="*/ 106325 h 563525"/>
                    <a:gd name="connsiteX23" fmla="*/ 159489 w 663783"/>
                    <a:gd name="connsiteY23" fmla="*/ 127591 h 563525"/>
                    <a:gd name="connsiteX24" fmla="*/ 0 w 663783"/>
                    <a:gd name="connsiteY24" fmla="*/ 138223 h 563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663783" h="563525">
                      <a:moveTo>
                        <a:pt x="21265" y="563525"/>
                      </a:moveTo>
                      <a:cubicBezTo>
                        <a:pt x="49619" y="559981"/>
                        <a:pt x="79795" y="563505"/>
                        <a:pt x="106326" y="552893"/>
                      </a:cubicBezTo>
                      <a:cubicBezTo>
                        <a:pt x="118191" y="548147"/>
                        <a:pt x="118555" y="530031"/>
                        <a:pt x="127591" y="520995"/>
                      </a:cubicBezTo>
                      <a:cubicBezTo>
                        <a:pt x="136627" y="511959"/>
                        <a:pt x="147743" y="504764"/>
                        <a:pt x="159489" y="499730"/>
                      </a:cubicBezTo>
                      <a:cubicBezTo>
                        <a:pt x="172920" y="493974"/>
                        <a:pt x="188022" y="493297"/>
                        <a:pt x="202019" y="489098"/>
                      </a:cubicBezTo>
                      <a:cubicBezTo>
                        <a:pt x="223489" y="482657"/>
                        <a:pt x="265814" y="467832"/>
                        <a:pt x="265814" y="467832"/>
                      </a:cubicBezTo>
                      <a:cubicBezTo>
                        <a:pt x="304800" y="409353"/>
                        <a:pt x="265813" y="458973"/>
                        <a:pt x="318977" y="414670"/>
                      </a:cubicBezTo>
                      <a:cubicBezTo>
                        <a:pt x="330529" y="405044"/>
                        <a:pt x="341249" y="394324"/>
                        <a:pt x="350875" y="382772"/>
                      </a:cubicBezTo>
                      <a:cubicBezTo>
                        <a:pt x="359056" y="372955"/>
                        <a:pt x="362161" y="358857"/>
                        <a:pt x="372140" y="350874"/>
                      </a:cubicBezTo>
                      <a:cubicBezTo>
                        <a:pt x="380891" y="343873"/>
                        <a:pt x="393405" y="343786"/>
                        <a:pt x="404037" y="340242"/>
                      </a:cubicBezTo>
                      <a:cubicBezTo>
                        <a:pt x="425302" y="326065"/>
                        <a:pt x="453656" y="318977"/>
                        <a:pt x="467833" y="297712"/>
                      </a:cubicBezTo>
                      <a:cubicBezTo>
                        <a:pt x="482010" y="276447"/>
                        <a:pt x="502281" y="258162"/>
                        <a:pt x="510363" y="233916"/>
                      </a:cubicBezTo>
                      <a:cubicBezTo>
                        <a:pt x="513907" y="223283"/>
                        <a:pt x="513995" y="210770"/>
                        <a:pt x="520996" y="202018"/>
                      </a:cubicBezTo>
                      <a:cubicBezTo>
                        <a:pt x="528979" y="192040"/>
                        <a:pt x="542261" y="187841"/>
                        <a:pt x="552893" y="180753"/>
                      </a:cubicBezTo>
                      <a:cubicBezTo>
                        <a:pt x="559981" y="170121"/>
                        <a:pt x="568968" y="160533"/>
                        <a:pt x="574158" y="148856"/>
                      </a:cubicBezTo>
                      <a:cubicBezTo>
                        <a:pt x="583262" y="128372"/>
                        <a:pt x="579572" y="100910"/>
                        <a:pt x="595423" y="85060"/>
                      </a:cubicBezTo>
                      <a:cubicBezTo>
                        <a:pt x="625725" y="54759"/>
                        <a:pt x="608348" y="69356"/>
                        <a:pt x="648586" y="42530"/>
                      </a:cubicBezTo>
                      <a:cubicBezTo>
                        <a:pt x="652130" y="28353"/>
                        <a:pt x="672787" y="5427"/>
                        <a:pt x="659219" y="0"/>
                      </a:cubicBezTo>
                      <a:cubicBezTo>
                        <a:pt x="659215" y="-1"/>
                        <a:pt x="579477" y="26581"/>
                        <a:pt x="563526" y="31898"/>
                      </a:cubicBezTo>
                      <a:cubicBezTo>
                        <a:pt x="497843" y="53792"/>
                        <a:pt x="542761" y="41417"/>
                        <a:pt x="425302" y="53163"/>
                      </a:cubicBezTo>
                      <a:cubicBezTo>
                        <a:pt x="361828" y="74320"/>
                        <a:pt x="407779" y="61479"/>
                        <a:pt x="297712" y="74428"/>
                      </a:cubicBezTo>
                      <a:lnTo>
                        <a:pt x="212651" y="85060"/>
                      </a:lnTo>
                      <a:cubicBezTo>
                        <a:pt x="202019" y="92148"/>
                        <a:pt x="190732" y="98342"/>
                        <a:pt x="180754" y="106325"/>
                      </a:cubicBezTo>
                      <a:cubicBezTo>
                        <a:pt x="172926" y="112587"/>
                        <a:pt x="168703" y="123642"/>
                        <a:pt x="159489" y="127591"/>
                      </a:cubicBezTo>
                      <a:cubicBezTo>
                        <a:pt x="118464" y="145173"/>
                        <a:pt x="32436" y="138223"/>
                        <a:pt x="0" y="138223"/>
                      </a:cubicBezTo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45" name="Textfeld 44"/>
                <p:cNvSpPr txBox="1"/>
                <p:nvPr/>
              </p:nvSpPr>
              <p:spPr>
                <a:xfrm>
                  <a:off x="5557478" y="6032545"/>
                  <a:ext cx="3433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4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i</a:t>
                  </a:r>
                </a:p>
              </p:txBody>
            </p:sp>
            <p:sp>
              <p:nvSpPr>
                <p:cNvPr id="35" name="Freihandform 34"/>
                <p:cNvSpPr/>
                <p:nvPr/>
              </p:nvSpPr>
              <p:spPr>
                <a:xfrm rot="255764">
                  <a:off x="6848171" y="6106339"/>
                  <a:ext cx="847681" cy="430520"/>
                </a:xfrm>
                <a:custGeom>
                  <a:avLst/>
                  <a:gdLst>
                    <a:gd name="connsiteX0" fmla="*/ 21385 w 500710"/>
                    <a:gd name="connsiteY0" fmla="*/ 404037 h 415687"/>
                    <a:gd name="connsiteX1" fmla="*/ 202139 w 500710"/>
                    <a:gd name="connsiteY1" fmla="*/ 393405 h 415687"/>
                    <a:gd name="connsiteX2" fmla="*/ 297832 w 500710"/>
                    <a:gd name="connsiteY2" fmla="*/ 340242 h 415687"/>
                    <a:gd name="connsiteX3" fmla="*/ 329730 w 500710"/>
                    <a:gd name="connsiteY3" fmla="*/ 329609 h 415687"/>
                    <a:gd name="connsiteX4" fmla="*/ 393525 w 500710"/>
                    <a:gd name="connsiteY4" fmla="*/ 287079 h 415687"/>
                    <a:gd name="connsiteX5" fmla="*/ 425423 w 500710"/>
                    <a:gd name="connsiteY5" fmla="*/ 265814 h 415687"/>
                    <a:gd name="connsiteX6" fmla="*/ 457320 w 500710"/>
                    <a:gd name="connsiteY6" fmla="*/ 244549 h 415687"/>
                    <a:gd name="connsiteX7" fmla="*/ 478585 w 500710"/>
                    <a:gd name="connsiteY7" fmla="*/ 212651 h 415687"/>
                    <a:gd name="connsiteX8" fmla="*/ 499851 w 500710"/>
                    <a:gd name="connsiteY8" fmla="*/ 191386 h 415687"/>
                    <a:gd name="connsiteX9" fmla="*/ 489218 w 500710"/>
                    <a:gd name="connsiteY9" fmla="*/ 85061 h 415687"/>
                    <a:gd name="connsiteX10" fmla="*/ 436055 w 500710"/>
                    <a:gd name="connsiteY10" fmla="*/ 42530 h 415687"/>
                    <a:gd name="connsiteX11" fmla="*/ 372260 w 500710"/>
                    <a:gd name="connsiteY11" fmla="*/ 21265 h 415687"/>
                    <a:gd name="connsiteX12" fmla="*/ 297832 w 500710"/>
                    <a:gd name="connsiteY12" fmla="*/ 0 h 415687"/>
                    <a:gd name="connsiteX13" fmla="*/ 234037 w 500710"/>
                    <a:gd name="connsiteY13" fmla="*/ 21265 h 415687"/>
                    <a:gd name="connsiteX14" fmla="*/ 180874 w 500710"/>
                    <a:gd name="connsiteY14" fmla="*/ 63795 h 415687"/>
                    <a:gd name="connsiteX15" fmla="*/ 117078 w 500710"/>
                    <a:gd name="connsiteY15" fmla="*/ 85061 h 415687"/>
                    <a:gd name="connsiteX16" fmla="*/ 85181 w 500710"/>
                    <a:gd name="connsiteY16" fmla="*/ 95693 h 415687"/>
                    <a:gd name="connsiteX17" fmla="*/ 53283 w 500710"/>
                    <a:gd name="connsiteY17" fmla="*/ 106326 h 415687"/>
                    <a:gd name="connsiteX18" fmla="*/ 21385 w 500710"/>
                    <a:gd name="connsiteY18" fmla="*/ 170121 h 415687"/>
                    <a:gd name="connsiteX19" fmla="*/ 32018 w 500710"/>
                    <a:gd name="connsiteY19" fmla="*/ 202019 h 415687"/>
                    <a:gd name="connsiteX20" fmla="*/ 21385 w 500710"/>
                    <a:gd name="connsiteY20" fmla="*/ 287079 h 415687"/>
                    <a:gd name="connsiteX21" fmla="*/ 120 w 500710"/>
                    <a:gd name="connsiteY21" fmla="*/ 318977 h 415687"/>
                    <a:gd name="connsiteX22" fmla="*/ 21385 w 500710"/>
                    <a:gd name="connsiteY22" fmla="*/ 414670 h 415687"/>
                    <a:gd name="connsiteX23" fmla="*/ 21385 w 500710"/>
                    <a:gd name="connsiteY23" fmla="*/ 404037 h 415687"/>
                    <a:gd name="connsiteX0" fmla="*/ 21385 w 500710"/>
                    <a:gd name="connsiteY0" fmla="*/ 404037 h 436638"/>
                    <a:gd name="connsiteX1" fmla="*/ 191506 w 500710"/>
                    <a:gd name="connsiteY1" fmla="*/ 435936 h 436638"/>
                    <a:gd name="connsiteX2" fmla="*/ 297832 w 500710"/>
                    <a:gd name="connsiteY2" fmla="*/ 340242 h 436638"/>
                    <a:gd name="connsiteX3" fmla="*/ 329730 w 500710"/>
                    <a:gd name="connsiteY3" fmla="*/ 329609 h 436638"/>
                    <a:gd name="connsiteX4" fmla="*/ 393525 w 500710"/>
                    <a:gd name="connsiteY4" fmla="*/ 287079 h 436638"/>
                    <a:gd name="connsiteX5" fmla="*/ 425423 w 500710"/>
                    <a:gd name="connsiteY5" fmla="*/ 265814 h 436638"/>
                    <a:gd name="connsiteX6" fmla="*/ 457320 w 500710"/>
                    <a:gd name="connsiteY6" fmla="*/ 244549 h 436638"/>
                    <a:gd name="connsiteX7" fmla="*/ 478585 w 500710"/>
                    <a:gd name="connsiteY7" fmla="*/ 212651 h 436638"/>
                    <a:gd name="connsiteX8" fmla="*/ 499851 w 500710"/>
                    <a:gd name="connsiteY8" fmla="*/ 191386 h 436638"/>
                    <a:gd name="connsiteX9" fmla="*/ 489218 w 500710"/>
                    <a:gd name="connsiteY9" fmla="*/ 85061 h 436638"/>
                    <a:gd name="connsiteX10" fmla="*/ 436055 w 500710"/>
                    <a:gd name="connsiteY10" fmla="*/ 42530 h 436638"/>
                    <a:gd name="connsiteX11" fmla="*/ 372260 w 500710"/>
                    <a:gd name="connsiteY11" fmla="*/ 21265 h 436638"/>
                    <a:gd name="connsiteX12" fmla="*/ 297832 w 500710"/>
                    <a:gd name="connsiteY12" fmla="*/ 0 h 436638"/>
                    <a:gd name="connsiteX13" fmla="*/ 234037 w 500710"/>
                    <a:gd name="connsiteY13" fmla="*/ 21265 h 436638"/>
                    <a:gd name="connsiteX14" fmla="*/ 180874 w 500710"/>
                    <a:gd name="connsiteY14" fmla="*/ 63795 h 436638"/>
                    <a:gd name="connsiteX15" fmla="*/ 117078 w 500710"/>
                    <a:gd name="connsiteY15" fmla="*/ 85061 h 436638"/>
                    <a:gd name="connsiteX16" fmla="*/ 85181 w 500710"/>
                    <a:gd name="connsiteY16" fmla="*/ 95693 h 436638"/>
                    <a:gd name="connsiteX17" fmla="*/ 53283 w 500710"/>
                    <a:gd name="connsiteY17" fmla="*/ 106326 h 436638"/>
                    <a:gd name="connsiteX18" fmla="*/ 21385 w 500710"/>
                    <a:gd name="connsiteY18" fmla="*/ 170121 h 436638"/>
                    <a:gd name="connsiteX19" fmla="*/ 32018 w 500710"/>
                    <a:gd name="connsiteY19" fmla="*/ 202019 h 436638"/>
                    <a:gd name="connsiteX20" fmla="*/ 21385 w 500710"/>
                    <a:gd name="connsiteY20" fmla="*/ 287079 h 436638"/>
                    <a:gd name="connsiteX21" fmla="*/ 120 w 500710"/>
                    <a:gd name="connsiteY21" fmla="*/ 318977 h 436638"/>
                    <a:gd name="connsiteX22" fmla="*/ 21385 w 500710"/>
                    <a:gd name="connsiteY22" fmla="*/ 414670 h 436638"/>
                    <a:gd name="connsiteX23" fmla="*/ 21385 w 500710"/>
                    <a:gd name="connsiteY23" fmla="*/ 404037 h 436638"/>
                    <a:gd name="connsiteX0" fmla="*/ 21385 w 500710"/>
                    <a:gd name="connsiteY0" fmla="*/ 404037 h 436638"/>
                    <a:gd name="connsiteX1" fmla="*/ 191506 w 500710"/>
                    <a:gd name="connsiteY1" fmla="*/ 435936 h 436638"/>
                    <a:gd name="connsiteX2" fmla="*/ 297832 w 500710"/>
                    <a:gd name="connsiteY2" fmla="*/ 340242 h 436638"/>
                    <a:gd name="connsiteX3" fmla="*/ 382893 w 500710"/>
                    <a:gd name="connsiteY3" fmla="*/ 361506 h 436638"/>
                    <a:gd name="connsiteX4" fmla="*/ 393525 w 500710"/>
                    <a:gd name="connsiteY4" fmla="*/ 287079 h 436638"/>
                    <a:gd name="connsiteX5" fmla="*/ 425423 w 500710"/>
                    <a:gd name="connsiteY5" fmla="*/ 265814 h 436638"/>
                    <a:gd name="connsiteX6" fmla="*/ 457320 w 500710"/>
                    <a:gd name="connsiteY6" fmla="*/ 244549 h 436638"/>
                    <a:gd name="connsiteX7" fmla="*/ 478585 w 500710"/>
                    <a:gd name="connsiteY7" fmla="*/ 212651 h 436638"/>
                    <a:gd name="connsiteX8" fmla="*/ 499851 w 500710"/>
                    <a:gd name="connsiteY8" fmla="*/ 191386 h 436638"/>
                    <a:gd name="connsiteX9" fmla="*/ 489218 w 500710"/>
                    <a:gd name="connsiteY9" fmla="*/ 85061 h 436638"/>
                    <a:gd name="connsiteX10" fmla="*/ 436055 w 500710"/>
                    <a:gd name="connsiteY10" fmla="*/ 42530 h 436638"/>
                    <a:gd name="connsiteX11" fmla="*/ 372260 w 500710"/>
                    <a:gd name="connsiteY11" fmla="*/ 21265 h 436638"/>
                    <a:gd name="connsiteX12" fmla="*/ 297832 w 500710"/>
                    <a:gd name="connsiteY12" fmla="*/ 0 h 436638"/>
                    <a:gd name="connsiteX13" fmla="*/ 234037 w 500710"/>
                    <a:gd name="connsiteY13" fmla="*/ 21265 h 436638"/>
                    <a:gd name="connsiteX14" fmla="*/ 180874 w 500710"/>
                    <a:gd name="connsiteY14" fmla="*/ 63795 h 436638"/>
                    <a:gd name="connsiteX15" fmla="*/ 117078 w 500710"/>
                    <a:gd name="connsiteY15" fmla="*/ 85061 h 436638"/>
                    <a:gd name="connsiteX16" fmla="*/ 85181 w 500710"/>
                    <a:gd name="connsiteY16" fmla="*/ 95693 h 436638"/>
                    <a:gd name="connsiteX17" fmla="*/ 53283 w 500710"/>
                    <a:gd name="connsiteY17" fmla="*/ 106326 h 436638"/>
                    <a:gd name="connsiteX18" fmla="*/ 21385 w 500710"/>
                    <a:gd name="connsiteY18" fmla="*/ 170121 h 436638"/>
                    <a:gd name="connsiteX19" fmla="*/ 32018 w 500710"/>
                    <a:gd name="connsiteY19" fmla="*/ 202019 h 436638"/>
                    <a:gd name="connsiteX20" fmla="*/ 21385 w 500710"/>
                    <a:gd name="connsiteY20" fmla="*/ 287079 h 436638"/>
                    <a:gd name="connsiteX21" fmla="*/ 120 w 500710"/>
                    <a:gd name="connsiteY21" fmla="*/ 318977 h 436638"/>
                    <a:gd name="connsiteX22" fmla="*/ 21385 w 500710"/>
                    <a:gd name="connsiteY22" fmla="*/ 414670 h 436638"/>
                    <a:gd name="connsiteX23" fmla="*/ 21385 w 500710"/>
                    <a:gd name="connsiteY23" fmla="*/ 404037 h 436638"/>
                    <a:gd name="connsiteX0" fmla="*/ 21385 w 500710"/>
                    <a:gd name="connsiteY0" fmla="*/ 404037 h 436210"/>
                    <a:gd name="connsiteX1" fmla="*/ 191506 w 500710"/>
                    <a:gd name="connsiteY1" fmla="*/ 435936 h 436210"/>
                    <a:gd name="connsiteX2" fmla="*/ 308465 w 500710"/>
                    <a:gd name="connsiteY2" fmla="*/ 382772 h 436210"/>
                    <a:gd name="connsiteX3" fmla="*/ 382893 w 500710"/>
                    <a:gd name="connsiteY3" fmla="*/ 361506 h 436210"/>
                    <a:gd name="connsiteX4" fmla="*/ 393525 w 500710"/>
                    <a:gd name="connsiteY4" fmla="*/ 287079 h 436210"/>
                    <a:gd name="connsiteX5" fmla="*/ 425423 w 500710"/>
                    <a:gd name="connsiteY5" fmla="*/ 265814 h 436210"/>
                    <a:gd name="connsiteX6" fmla="*/ 457320 w 500710"/>
                    <a:gd name="connsiteY6" fmla="*/ 244549 h 436210"/>
                    <a:gd name="connsiteX7" fmla="*/ 478585 w 500710"/>
                    <a:gd name="connsiteY7" fmla="*/ 212651 h 436210"/>
                    <a:gd name="connsiteX8" fmla="*/ 499851 w 500710"/>
                    <a:gd name="connsiteY8" fmla="*/ 191386 h 436210"/>
                    <a:gd name="connsiteX9" fmla="*/ 489218 w 500710"/>
                    <a:gd name="connsiteY9" fmla="*/ 85061 h 436210"/>
                    <a:gd name="connsiteX10" fmla="*/ 436055 w 500710"/>
                    <a:gd name="connsiteY10" fmla="*/ 42530 h 436210"/>
                    <a:gd name="connsiteX11" fmla="*/ 372260 w 500710"/>
                    <a:gd name="connsiteY11" fmla="*/ 21265 h 436210"/>
                    <a:gd name="connsiteX12" fmla="*/ 297832 w 500710"/>
                    <a:gd name="connsiteY12" fmla="*/ 0 h 436210"/>
                    <a:gd name="connsiteX13" fmla="*/ 234037 w 500710"/>
                    <a:gd name="connsiteY13" fmla="*/ 21265 h 436210"/>
                    <a:gd name="connsiteX14" fmla="*/ 180874 w 500710"/>
                    <a:gd name="connsiteY14" fmla="*/ 63795 h 436210"/>
                    <a:gd name="connsiteX15" fmla="*/ 117078 w 500710"/>
                    <a:gd name="connsiteY15" fmla="*/ 85061 h 436210"/>
                    <a:gd name="connsiteX16" fmla="*/ 85181 w 500710"/>
                    <a:gd name="connsiteY16" fmla="*/ 95693 h 436210"/>
                    <a:gd name="connsiteX17" fmla="*/ 53283 w 500710"/>
                    <a:gd name="connsiteY17" fmla="*/ 106326 h 436210"/>
                    <a:gd name="connsiteX18" fmla="*/ 21385 w 500710"/>
                    <a:gd name="connsiteY18" fmla="*/ 170121 h 436210"/>
                    <a:gd name="connsiteX19" fmla="*/ 32018 w 500710"/>
                    <a:gd name="connsiteY19" fmla="*/ 202019 h 436210"/>
                    <a:gd name="connsiteX20" fmla="*/ 21385 w 500710"/>
                    <a:gd name="connsiteY20" fmla="*/ 287079 h 436210"/>
                    <a:gd name="connsiteX21" fmla="*/ 120 w 500710"/>
                    <a:gd name="connsiteY21" fmla="*/ 318977 h 436210"/>
                    <a:gd name="connsiteX22" fmla="*/ 21385 w 500710"/>
                    <a:gd name="connsiteY22" fmla="*/ 414670 h 436210"/>
                    <a:gd name="connsiteX23" fmla="*/ 21385 w 500710"/>
                    <a:gd name="connsiteY23" fmla="*/ 404037 h 436210"/>
                    <a:gd name="connsiteX0" fmla="*/ 21385 w 500710"/>
                    <a:gd name="connsiteY0" fmla="*/ 404037 h 436210"/>
                    <a:gd name="connsiteX1" fmla="*/ 191506 w 500710"/>
                    <a:gd name="connsiteY1" fmla="*/ 435936 h 436210"/>
                    <a:gd name="connsiteX2" fmla="*/ 308465 w 500710"/>
                    <a:gd name="connsiteY2" fmla="*/ 382772 h 436210"/>
                    <a:gd name="connsiteX3" fmla="*/ 382893 w 500710"/>
                    <a:gd name="connsiteY3" fmla="*/ 361506 h 436210"/>
                    <a:gd name="connsiteX4" fmla="*/ 393525 w 500710"/>
                    <a:gd name="connsiteY4" fmla="*/ 287079 h 436210"/>
                    <a:gd name="connsiteX5" fmla="*/ 457321 w 500710"/>
                    <a:gd name="connsiteY5" fmla="*/ 297711 h 436210"/>
                    <a:gd name="connsiteX6" fmla="*/ 457320 w 500710"/>
                    <a:gd name="connsiteY6" fmla="*/ 244549 h 436210"/>
                    <a:gd name="connsiteX7" fmla="*/ 478585 w 500710"/>
                    <a:gd name="connsiteY7" fmla="*/ 212651 h 436210"/>
                    <a:gd name="connsiteX8" fmla="*/ 499851 w 500710"/>
                    <a:gd name="connsiteY8" fmla="*/ 191386 h 436210"/>
                    <a:gd name="connsiteX9" fmla="*/ 489218 w 500710"/>
                    <a:gd name="connsiteY9" fmla="*/ 85061 h 436210"/>
                    <a:gd name="connsiteX10" fmla="*/ 436055 w 500710"/>
                    <a:gd name="connsiteY10" fmla="*/ 42530 h 436210"/>
                    <a:gd name="connsiteX11" fmla="*/ 372260 w 500710"/>
                    <a:gd name="connsiteY11" fmla="*/ 21265 h 436210"/>
                    <a:gd name="connsiteX12" fmla="*/ 297832 w 500710"/>
                    <a:gd name="connsiteY12" fmla="*/ 0 h 436210"/>
                    <a:gd name="connsiteX13" fmla="*/ 234037 w 500710"/>
                    <a:gd name="connsiteY13" fmla="*/ 21265 h 436210"/>
                    <a:gd name="connsiteX14" fmla="*/ 180874 w 500710"/>
                    <a:gd name="connsiteY14" fmla="*/ 63795 h 436210"/>
                    <a:gd name="connsiteX15" fmla="*/ 117078 w 500710"/>
                    <a:gd name="connsiteY15" fmla="*/ 85061 h 436210"/>
                    <a:gd name="connsiteX16" fmla="*/ 85181 w 500710"/>
                    <a:gd name="connsiteY16" fmla="*/ 95693 h 436210"/>
                    <a:gd name="connsiteX17" fmla="*/ 53283 w 500710"/>
                    <a:gd name="connsiteY17" fmla="*/ 106326 h 436210"/>
                    <a:gd name="connsiteX18" fmla="*/ 21385 w 500710"/>
                    <a:gd name="connsiteY18" fmla="*/ 170121 h 436210"/>
                    <a:gd name="connsiteX19" fmla="*/ 32018 w 500710"/>
                    <a:gd name="connsiteY19" fmla="*/ 202019 h 436210"/>
                    <a:gd name="connsiteX20" fmla="*/ 21385 w 500710"/>
                    <a:gd name="connsiteY20" fmla="*/ 287079 h 436210"/>
                    <a:gd name="connsiteX21" fmla="*/ 120 w 500710"/>
                    <a:gd name="connsiteY21" fmla="*/ 318977 h 436210"/>
                    <a:gd name="connsiteX22" fmla="*/ 21385 w 500710"/>
                    <a:gd name="connsiteY22" fmla="*/ 414670 h 436210"/>
                    <a:gd name="connsiteX23" fmla="*/ 21385 w 500710"/>
                    <a:gd name="connsiteY23" fmla="*/ 404037 h 436210"/>
                    <a:gd name="connsiteX0" fmla="*/ 21385 w 500710"/>
                    <a:gd name="connsiteY0" fmla="*/ 404037 h 436210"/>
                    <a:gd name="connsiteX1" fmla="*/ 191506 w 500710"/>
                    <a:gd name="connsiteY1" fmla="*/ 435936 h 436210"/>
                    <a:gd name="connsiteX2" fmla="*/ 308465 w 500710"/>
                    <a:gd name="connsiteY2" fmla="*/ 382772 h 436210"/>
                    <a:gd name="connsiteX3" fmla="*/ 382893 w 500710"/>
                    <a:gd name="connsiteY3" fmla="*/ 361506 h 436210"/>
                    <a:gd name="connsiteX4" fmla="*/ 414790 w 500710"/>
                    <a:gd name="connsiteY4" fmla="*/ 318977 h 436210"/>
                    <a:gd name="connsiteX5" fmla="*/ 457321 w 500710"/>
                    <a:gd name="connsiteY5" fmla="*/ 297711 h 436210"/>
                    <a:gd name="connsiteX6" fmla="*/ 457320 w 500710"/>
                    <a:gd name="connsiteY6" fmla="*/ 244549 h 436210"/>
                    <a:gd name="connsiteX7" fmla="*/ 478585 w 500710"/>
                    <a:gd name="connsiteY7" fmla="*/ 212651 h 436210"/>
                    <a:gd name="connsiteX8" fmla="*/ 499851 w 500710"/>
                    <a:gd name="connsiteY8" fmla="*/ 191386 h 436210"/>
                    <a:gd name="connsiteX9" fmla="*/ 489218 w 500710"/>
                    <a:gd name="connsiteY9" fmla="*/ 85061 h 436210"/>
                    <a:gd name="connsiteX10" fmla="*/ 436055 w 500710"/>
                    <a:gd name="connsiteY10" fmla="*/ 42530 h 436210"/>
                    <a:gd name="connsiteX11" fmla="*/ 372260 w 500710"/>
                    <a:gd name="connsiteY11" fmla="*/ 21265 h 436210"/>
                    <a:gd name="connsiteX12" fmla="*/ 297832 w 500710"/>
                    <a:gd name="connsiteY12" fmla="*/ 0 h 436210"/>
                    <a:gd name="connsiteX13" fmla="*/ 234037 w 500710"/>
                    <a:gd name="connsiteY13" fmla="*/ 21265 h 436210"/>
                    <a:gd name="connsiteX14" fmla="*/ 180874 w 500710"/>
                    <a:gd name="connsiteY14" fmla="*/ 63795 h 436210"/>
                    <a:gd name="connsiteX15" fmla="*/ 117078 w 500710"/>
                    <a:gd name="connsiteY15" fmla="*/ 85061 h 436210"/>
                    <a:gd name="connsiteX16" fmla="*/ 85181 w 500710"/>
                    <a:gd name="connsiteY16" fmla="*/ 95693 h 436210"/>
                    <a:gd name="connsiteX17" fmla="*/ 53283 w 500710"/>
                    <a:gd name="connsiteY17" fmla="*/ 106326 h 436210"/>
                    <a:gd name="connsiteX18" fmla="*/ 21385 w 500710"/>
                    <a:gd name="connsiteY18" fmla="*/ 170121 h 436210"/>
                    <a:gd name="connsiteX19" fmla="*/ 32018 w 500710"/>
                    <a:gd name="connsiteY19" fmla="*/ 202019 h 436210"/>
                    <a:gd name="connsiteX20" fmla="*/ 21385 w 500710"/>
                    <a:gd name="connsiteY20" fmla="*/ 287079 h 436210"/>
                    <a:gd name="connsiteX21" fmla="*/ 120 w 500710"/>
                    <a:gd name="connsiteY21" fmla="*/ 318977 h 436210"/>
                    <a:gd name="connsiteX22" fmla="*/ 21385 w 500710"/>
                    <a:gd name="connsiteY22" fmla="*/ 414670 h 436210"/>
                    <a:gd name="connsiteX23" fmla="*/ 21385 w 500710"/>
                    <a:gd name="connsiteY23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372260 w 491350"/>
                    <a:gd name="connsiteY10" fmla="*/ 21265 h 436210"/>
                    <a:gd name="connsiteX11" fmla="*/ 297832 w 491350"/>
                    <a:gd name="connsiteY11" fmla="*/ 0 h 436210"/>
                    <a:gd name="connsiteX12" fmla="*/ 234037 w 491350"/>
                    <a:gd name="connsiteY12" fmla="*/ 21265 h 436210"/>
                    <a:gd name="connsiteX13" fmla="*/ 180874 w 491350"/>
                    <a:gd name="connsiteY13" fmla="*/ 63795 h 436210"/>
                    <a:gd name="connsiteX14" fmla="*/ 117078 w 491350"/>
                    <a:gd name="connsiteY14" fmla="*/ 85061 h 436210"/>
                    <a:gd name="connsiteX15" fmla="*/ 85181 w 491350"/>
                    <a:gd name="connsiteY15" fmla="*/ 95693 h 436210"/>
                    <a:gd name="connsiteX16" fmla="*/ 53283 w 491350"/>
                    <a:gd name="connsiteY16" fmla="*/ 106326 h 436210"/>
                    <a:gd name="connsiteX17" fmla="*/ 21385 w 491350"/>
                    <a:gd name="connsiteY17" fmla="*/ 170121 h 436210"/>
                    <a:gd name="connsiteX18" fmla="*/ 32018 w 491350"/>
                    <a:gd name="connsiteY18" fmla="*/ 202019 h 436210"/>
                    <a:gd name="connsiteX19" fmla="*/ 21385 w 491350"/>
                    <a:gd name="connsiteY19" fmla="*/ 287079 h 436210"/>
                    <a:gd name="connsiteX20" fmla="*/ 120 w 491350"/>
                    <a:gd name="connsiteY20" fmla="*/ 318977 h 436210"/>
                    <a:gd name="connsiteX21" fmla="*/ 21385 w 491350"/>
                    <a:gd name="connsiteY21" fmla="*/ 414670 h 436210"/>
                    <a:gd name="connsiteX22" fmla="*/ 21385 w 491350"/>
                    <a:gd name="connsiteY22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297832 w 491350"/>
                    <a:gd name="connsiteY10" fmla="*/ 0 h 436210"/>
                    <a:gd name="connsiteX11" fmla="*/ 234037 w 491350"/>
                    <a:gd name="connsiteY11" fmla="*/ 21265 h 436210"/>
                    <a:gd name="connsiteX12" fmla="*/ 180874 w 491350"/>
                    <a:gd name="connsiteY12" fmla="*/ 63795 h 436210"/>
                    <a:gd name="connsiteX13" fmla="*/ 117078 w 491350"/>
                    <a:gd name="connsiteY13" fmla="*/ 85061 h 436210"/>
                    <a:gd name="connsiteX14" fmla="*/ 85181 w 491350"/>
                    <a:gd name="connsiteY14" fmla="*/ 95693 h 436210"/>
                    <a:gd name="connsiteX15" fmla="*/ 53283 w 491350"/>
                    <a:gd name="connsiteY15" fmla="*/ 106326 h 436210"/>
                    <a:gd name="connsiteX16" fmla="*/ 21385 w 491350"/>
                    <a:gd name="connsiteY16" fmla="*/ 170121 h 436210"/>
                    <a:gd name="connsiteX17" fmla="*/ 32018 w 491350"/>
                    <a:gd name="connsiteY17" fmla="*/ 202019 h 436210"/>
                    <a:gd name="connsiteX18" fmla="*/ 21385 w 491350"/>
                    <a:gd name="connsiteY18" fmla="*/ 287079 h 436210"/>
                    <a:gd name="connsiteX19" fmla="*/ 120 w 491350"/>
                    <a:gd name="connsiteY19" fmla="*/ 318977 h 436210"/>
                    <a:gd name="connsiteX20" fmla="*/ 21385 w 491350"/>
                    <a:gd name="connsiteY20" fmla="*/ 414670 h 436210"/>
                    <a:gd name="connsiteX21" fmla="*/ 21385 w 491350"/>
                    <a:gd name="connsiteY21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297832 w 491350"/>
                    <a:gd name="connsiteY10" fmla="*/ 0 h 436210"/>
                    <a:gd name="connsiteX11" fmla="*/ 234037 w 491350"/>
                    <a:gd name="connsiteY11" fmla="*/ 21265 h 436210"/>
                    <a:gd name="connsiteX12" fmla="*/ 117078 w 491350"/>
                    <a:gd name="connsiteY12" fmla="*/ 85061 h 436210"/>
                    <a:gd name="connsiteX13" fmla="*/ 85181 w 491350"/>
                    <a:gd name="connsiteY13" fmla="*/ 95693 h 436210"/>
                    <a:gd name="connsiteX14" fmla="*/ 53283 w 491350"/>
                    <a:gd name="connsiteY14" fmla="*/ 106326 h 436210"/>
                    <a:gd name="connsiteX15" fmla="*/ 21385 w 491350"/>
                    <a:gd name="connsiteY15" fmla="*/ 170121 h 436210"/>
                    <a:gd name="connsiteX16" fmla="*/ 32018 w 491350"/>
                    <a:gd name="connsiteY16" fmla="*/ 202019 h 436210"/>
                    <a:gd name="connsiteX17" fmla="*/ 21385 w 491350"/>
                    <a:gd name="connsiteY17" fmla="*/ 287079 h 436210"/>
                    <a:gd name="connsiteX18" fmla="*/ 120 w 491350"/>
                    <a:gd name="connsiteY18" fmla="*/ 318977 h 436210"/>
                    <a:gd name="connsiteX19" fmla="*/ 21385 w 491350"/>
                    <a:gd name="connsiteY19" fmla="*/ 414670 h 436210"/>
                    <a:gd name="connsiteX20" fmla="*/ 21385 w 491350"/>
                    <a:gd name="connsiteY20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297832 w 491350"/>
                    <a:gd name="connsiteY10" fmla="*/ 0 h 436210"/>
                    <a:gd name="connsiteX11" fmla="*/ 234037 w 491350"/>
                    <a:gd name="connsiteY11" fmla="*/ 21265 h 436210"/>
                    <a:gd name="connsiteX12" fmla="*/ 117078 w 491350"/>
                    <a:gd name="connsiteY12" fmla="*/ 85061 h 436210"/>
                    <a:gd name="connsiteX13" fmla="*/ 85181 w 491350"/>
                    <a:gd name="connsiteY13" fmla="*/ 95693 h 436210"/>
                    <a:gd name="connsiteX14" fmla="*/ 21385 w 491350"/>
                    <a:gd name="connsiteY14" fmla="*/ 170121 h 436210"/>
                    <a:gd name="connsiteX15" fmla="*/ 32018 w 491350"/>
                    <a:gd name="connsiteY15" fmla="*/ 202019 h 436210"/>
                    <a:gd name="connsiteX16" fmla="*/ 21385 w 491350"/>
                    <a:gd name="connsiteY16" fmla="*/ 287079 h 436210"/>
                    <a:gd name="connsiteX17" fmla="*/ 120 w 491350"/>
                    <a:gd name="connsiteY17" fmla="*/ 318977 h 436210"/>
                    <a:gd name="connsiteX18" fmla="*/ 21385 w 491350"/>
                    <a:gd name="connsiteY18" fmla="*/ 414670 h 436210"/>
                    <a:gd name="connsiteX19" fmla="*/ 21385 w 491350"/>
                    <a:gd name="connsiteY19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297832 w 491350"/>
                    <a:gd name="connsiteY10" fmla="*/ 0 h 436210"/>
                    <a:gd name="connsiteX11" fmla="*/ 234037 w 491350"/>
                    <a:gd name="connsiteY11" fmla="*/ 21265 h 436210"/>
                    <a:gd name="connsiteX12" fmla="*/ 117078 w 491350"/>
                    <a:gd name="connsiteY12" fmla="*/ 85061 h 436210"/>
                    <a:gd name="connsiteX13" fmla="*/ 85181 w 491350"/>
                    <a:gd name="connsiteY13" fmla="*/ 95693 h 436210"/>
                    <a:gd name="connsiteX14" fmla="*/ 21385 w 491350"/>
                    <a:gd name="connsiteY14" fmla="*/ 170121 h 436210"/>
                    <a:gd name="connsiteX15" fmla="*/ 21385 w 491350"/>
                    <a:gd name="connsiteY15" fmla="*/ 287079 h 436210"/>
                    <a:gd name="connsiteX16" fmla="*/ 120 w 491350"/>
                    <a:gd name="connsiteY16" fmla="*/ 318977 h 436210"/>
                    <a:gd name="connsiteX17" fmla="*/ 21385 w 491350"/>
                    <a:gd name="connsiteY17" fmla="*/ 414670 h 436210"/>
                    <a:gd name="connsiteX18" fmla="*/ 21385 w 491350"/>
                    <a:gd name="connsiteY18" fmla="*/ 404037 h 436210"/>
                    <a:gd name="connsiteX0" fmla="*/ 21385 w 491350"/>
                    <a:gd name="connsiteY0" fmla="*/ 404037 h 436210"/>
                    <a:gd name="connsiteX1" fmla="*/ 191506 w 491350"/>
                    <a:gd name="connsiteY1" fmla="*/ 435936 h 436210"/>
                    <a:gd name="connsiteX2" fmla="*/ 308465 w 491350"/>
                    <a:gd name="connsiteY2" fmla="*/ 382772 h 436210"/>
                    <a:gd name="connsiteX3" fmla="*/ 382893 w 491350"/>
                    <a:gd name="connsiteY3" fmla="*/ 361506 h 436210"/>
                    <a:gd name="connsiteX4" fmla="*/ 414790 w 491350"/>
                    <a:gd name="connsiteY4" fmla="*/ 318977 h 436210"/>
                    <a:gd name="connsiteX5" fmla="*/ 457321 w 491350"/>
                    <a:gd name="connsiteY5" fmla="*/ 297711 h 436210"/>
                    <a:gd name="connsiteX6" fmla="*/ 457320 w 491350"/>
                    <a:gd name="connsiteY6" fmla="*/ 244549 h 436210"/>
                    <a:gd name="connsiteX7" fmla="*/ 478585 w 491350"/>
                    <a:gd name="connsiteY7" fmla="*/ 212651 h 436210"/>
                    <a:gd name="connsiteX8" fmla="*/ 489218 w 491350"/>
                    <a:gd name="connsiteY8" fmla="*/ 85061 h 436210"/>
                    <a:gd name="connsiteX9" fmla="*/ 436055 w 491350"/>
                    <a:gd name="connsiteY9" fmla="*/ 42530 h 436210"/>
                    <a:gd name="connsiteX10" fmla="*/ 297832 w 491350"/>
                    <a:gd name="connsiteY10" fmla="*/ 0 h 436210"/>
                    <a:gd name="connsiteX11" fmla="*/ 234037 w 491350"/>
                    <a:gd name="connsiteY11" fmla="*/ 21265 h 436210"/>
                    <a:gd name="connsiteX12" fmla="*/ 117078 w 491350"/>
                    <a:gd name="connsiteY12" fmla="*/ 85061 h 436210"/>
                    <a:gd name="connsiteX13" fmla="*/ 85181 w 491350"/>
                    <a:gd name="connsiteY13" fmla="*/ 95693 h 436210"/>
                    <a:gd name="connsiteX14" fmla="*/ 21385 w 491350"/>
                    <a:gd name="connsiteY14" fmla="*/ 170121 h 436210"/>
                    <a:gd name="connsiteX15" fmla="*/ 120 w 491350"/>
                    <a:gd name="connsiteY15" fmla="*/ 318977 h 436210"/>
                    <a:gd name="connsiteX16" fmla="*/ 21385 w 491350"/>
                    <a:gd name="connsiteY16" fmla="*/ 414670 h 436210"/>
                    <a:gd name="connsiteX17" fmla="*/ 21385 w 491350"/>
                    <a:gd name="connsiteY17" fmla="*/ 404037 h 436210"/>
                    <a:gd name="connsiteX0" fmla="*/ 21385 w 511631"/>
                    <a:gd name="connsiteY0" fmla="*/ 404037 h 436210"/>
                    <a:gd name="connsiteX1" fmla="*/ 191506 w 511631"/>
                    <a:gd name="connsiteY1" fmla="*/ 435936 h 436210"/>
                    <a:gd name="connsiteX2" fmla="*/ 308465 w 511631"/>
                    <a:gd name="connsiteY2" fmla="*/ 382772 h 436210"/>
                    <a:gd name="connsiteX3" fmla="*/ 382893 w 511631"/>
                    <a:gd name="connsiteY3" fmla="*/ 361506 h 436210"/>
                    <a:gd name="connsiteX4" fmla="*/ 414790 w 511631"/>
                    <a:gd name="connsiteY4" fmla="*/ 318977 h 436210"/>
                    <a:gd name="connsiteX5" fmla="*/ 457321 w 511631"/>
                    <a:gd name="connsiteY5" fmla="*/ 297711 h 436210"/>
                    <a:gd name="connsiteX6" fmla="*/ 457320 w 511631"/>
                    <a:gd name="connsiteY6" fmla="*/ 244549 h 436210"/>
                    <a:gd name="connsiteX7" fmla="*/ 510483 w 511631"/>
                    <a:gd name="connsiteY7" fmla="*/ 191386 h 436210"/>
                    <a:gd name="connsiteX8" fmla="*/ 489218 w 511631"/>
                    <a:gd name="connsiteY8" fmla="*/ 85061 h 436210"/>
                    <a:gd name="connsiteX9" fmla="*/ 436055 w 511631"/>
                    <a:gd name="connsiteY9" fmla="*/ 42530 h 436210"/>
                    <a:gd name="connsiteX10" fmla="*/ 297832 w 511631"/>
                    <a:gd name="connsiteY10" fmla="*/ 0 h 436210"/>
                    <a:gd name="connsiteX11" fmla="*/ 234037 w 511631"/>
                    <a:gd name="connsiteY11" fmla="*/ 21265 h 436210"/>
                    <a:gd name="connsiteX12" fmla="*/ 117078 w 511631"/>
                    <a:gd name="connsiteY12" fmla="*/ 85061 h 436210"/>
                    <a:gd name="connsiteX13" fmla="*/ 85181 w 511631"/>
                    <a:gd name="connsiteY13" fmla="*/ 95693 h 436210"/>
                    <a:gd name="connsiteX14" fmla="*/ 21385 w 511631"/>
                    <a:gd name="connsiteY14" fmla="*/ 170121 h 436210"/>
                    <a:gd name="connsiteX15" fmla="*/ 120 w 511631"/>
                    <a:gd name="connsiteY15" fmla="*/ 318977 h 436210"/>
                    <a:gd name="connsiteX16" fmla="*/ 21385 w 511631"/>
                    <a:gd name="connsiteY16" fmla="*/ 414670 h 436210"/>
                    <a:gd name="connsiteX17" fmla="*/ 21385 w 511631"/>
                    <a:gd name="connsiteY17" fmla="*/ 404037 h 436210"/>
                    <a:gd name="connsiteX0" fmla="*/ 21385 w 511631"/>
                    <a:gd name="connsiteY0" fmla="*/ 404037 h 436210"/>
                    <a:gd name="connsiteX1" fmla="*/ 191506 w 511631"/>
                    <a:gd name="connsiteY1" fmla="*/ 435936 h 436210"/>
                    <a:gd name="connsiteX2" fmla="*/ 308465 w 511631"/>
                    <a:gd name="connsiteY2" fmla="*/ 382772 h 436210"/>
                    <a:gd name="connsiteX3" fmla="*/ 382893 w 511631"/>
                    <a:gd name="connsiteY3" fmla="*/ 361506 h 436210"/>
                    <a:gd name="connsiteX4" fmla="*/ 414790 w 511631"/>
                    <a:gd name="connsiteY4" fmla="*/ 318977 h 436210"/>
                    <a:gd name="connsiteX5" fmla="*/ 457320 w 511631"/>
                    <a:gd name="connsiteY5" fmla="*/ 244549 h 436210"/>
                    <a:gd name="connsiteX6" fmla="*/ 510483 w 511631"/>
                    <a:gd name="connsiteY6" fmla="*/ 191386 h 436210"/>
                    <a:gd name="connsiteX7" fmla="*/ 489218 w 511631"/>
                    <a:gd name="connsiteY7" fmla="*/ 85061 h 436210"/>
                    <a:gd name="connsiteX8" fmla="*/ 436055 w 511631"/>
                    <a:gd name="connsiteY8" fmla="*/ 42530 h 436210"/>
                    <a:gd name="connsiteX9" fmla="*/ 297832 w 511631"/>
                    <a:gd name="connsiteY9" fmla="*/ 0 h 436210"/>
                    <a:gd name="connsiteX10" fmla="*/ 234037 w 511631"/>
                    <a:gd name="connsiteY10" fmla="*/ 21265 h 436210"/>
                    <a:gd name="connsiteX11" fmla="*/ 117078 w 511631"/>
                    <a:gd name="connsiteY11" fmla="*/ 85061 h 436210"/>
                    <a:gd name="connsiteX12" fmla="*/ 85181 w 511631"/>
                    <a:gd name="connsiteY12" fmla="*/ 95693 h 436210"/>
                    <a:gd name="connsiteX13" fmla="*/ 21385 w 511631"/>
                    <a:gd name="connsiteY13" fmla="*/ 170121 h 436210"/>
                    <a:gd name="connsiteX14" fmla="*/ 120 w 511631"/>
                    <a:gd name="connsiteY14" fmla="*/ 318977 h 436210"/>
                    <a:gd name="connsiteX15" fmla="*/ 21385 w 511631"/>
                    <a:gd name="connsiteY15" fmla="*/ 414670 h 436210"/>
                    <a:gd name="connsiteX16" fmla="*/ 21385 w 511631"/>
                    <a:gd name="connsiteY16" fmla="*/ 404037 h 43621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511631" h="436210">
                      <a:moveTo>
                        <a:pt x="21385" y="404037"/>
                      </a:moveTo>
                      <a:cubicBezTo>
                        <a:pt x="49738" y="407581"/>
                        <a:pt x="143659" y="439480"/>
                        <a:pt x="191506" y="435936"/>
                      </a:cubicBezTo>
                      <a:cubicBezTo>
                        <a:pt x="239353" y="432392"/>
                        <a:pt x="276567" y="395177"/>
                        <a:pt x="308465" y="382772"/>
                      </a:cubicBezTo>
                      <a:cubicBezTo>
                        <a:pt x="340363" y="370367"/>
                        <a:pt x="365172" y="372138"/>
                        <a:pt x="382893" y="361506"/>
                      </a:cubicBezTo>
                      <a:cubicBezTo>
                        <a:pt x="400614" y="350874"/>
                        <a:pt x="402386" y="338470"/>
                        <a:pt x="414790" y="318977"/>
                      </a:cubicBezTo>
                      <a:cubicBezTo>
                        <a:pt x="427195" y="299484"/>
                        <a:pt x="441371" y="265814"/>
                        <a:pt x="457320" y="244549"/>
                      </a:cubicBezTo>
                      <a:cubicBezTo>
                        <a:pt x="473269" y="223284"/>
                        <a:pt x="505167" y="217967"/>
                        <a:pt x="510483" y="191386"/>
                      </a:cubicBezTo>
                      <a:cubicBezTo>
                        <a:pt x="515799" y="164805"/>
                        <a:pt x="501623" y="109870"/>
                        <a:pt x="489218" y="85061"/>
                      </a:cubicBezTo>
                      <a:cubicBezTo>
                        <a:pt x="476813" y="60252"/>
                        <a:pt x="467953" y="56707"/>
                        <a:pt x="436055" y="42530"/>
                      </a:cubicBezTo>
                      <a:cubicBezTo>
                        <a:pt x="404157" y="28353"/>
                        <a:pt x="331502" y="3544"/>
                        <a:pt x="297832" y="0"/>
                      </a:cubicBezTo>
                      <a:cubicBezTo>
                        <a:pt x="276567" y="7088"/>
                        <a:pt x="264163" y="7088"/>
                        <a:pt x="234037" y="21265"/>
                      </a:cubicBezTo>
                      <a:cubicBezTo>
                        <a:pt x="203911" y="35442"/>
                        <a:pt x="141887" y="72656"/>
                        <a:pt x="117078" y="85061"/>
                      </a:cubicBezTo>
                      <a:cubicBezTo>
                        <a:pt x="92269" y="97466"/>
                        <a:pt x="95813" y="92149"/>
                        <a:pt x="85181" y="95693"/>
                      </a:cubicBezTo>
                      <a:cubicBezTo>
                        <a:pt x="63916" y="120502"/>
                        <a:pt x="35562" y="132907"/>
                        <a:pt x="21385" y="170121"/>
                      </a:cubicBezTo>
                      <a:cubicBezTo>
                        <a:pt x="7208" y="207335"/>
                        <a:pt x="120" y="278219"/>
                        <a:pt x="120" y="318977"/>
                      </a:cubicBezTo>
                      <a:cubicBezTo>
                        <a:pt x="-1364" y="332337"/>
                        <a:pt x="11194" y="394287"/>
                        <a:pt x="21385" y="414670"/>
                      </a:cubicBezTo>
                      <a:cubicBezTo>
                        <a:pt x="23627" y="419153"/>
                        <a:pt x="-6968" y="400493"/>
                        <a:pt x="21385" y="404037"/>
                      </a:cubicBez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</p:grpSp>
          <p:sp>
            <p:nvSpPr>
              <p:cNvPr id="47" name="Textfeld 46"/>
              <p:cNvSpPr txBox="1"/>
              <p:nvPr/>
            </p:nvSpPr>
            <p:spPr>
              <a:xfrm>
                <a:off x="6407174" y="5412582"/>
                <a:ext cx="2595231" cy="222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u="sng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Organs </a:t>
                </a:r>
                <a:r>
                  <a:rPr lang="de-DE" sz="1200" b="1" u="sng" dirty="0" err="1">
                    <a:latin typeface="Palatino Linotype" panose="02040502050505030304" pitchFamily="18" charset="0"/>
                    <a:cs typeface="Arial" panose="020B0604020202020204" pitchFamily="34" charset="0"/>
                  </a:rPr>
                  <a:t>visible</a:t>
                </a:r>
                <a:r>
                  <a:rPr lang="de-DE" sz="1200" b="1" u="sng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 in Video B </a:t>
                </a:r>
                <a:r>
                  <a:rPr lang="de-DE" sz="1200" b="1" u="sng" dirty="0" err="1">
                    <a:latin typeface="Palatino Linotype" panose="02040502050505030304" pitchFamily="18" charset="0"/>
                    <a:cs typeface="Arial" panose="020B0604020202020204" pitchFamily="34" charset="0"/>
                  </a:rPr>
                  <a:t>before</a:t>
                </a:r>
                <a:r>
                  <a:rPr lang="de-DE" sz="1200" b="1" u="sng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 </a:t>
                </a:r>
                <a:r>
                  <a:rPr lang="de-DE" sz="1200" b="1" u="sng" dirty="0" err="1">
                    <a:latin typeface="Palatino Linotype" panose="02040502050505030304" pitchFamily="18" charset="0"/>
                    <a:cs typeface="Arial" panose="020B0604020202020204" pitchFamily="34" charset="0"/>
                  </a:rPr>
                  <a:t>the</a:t>
                </a:r>
                <a:r>
                  <a:rPr lang="de-DE" sz="1200" b="1" u="sng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 </a:t>
                </a:r>
                <a:r>
                  <a:rPr lang="de-DE" sz="1200" b="1" u="sng" dirty="0" err="1">
                    <a:latin typeface="Palatino Linotype" panose="02040502050505030304" pitchFamily="18" charset="0"/>
                    <a:cs typeface="Arial" panose="020B0604020202020204" pitchFamily="34" charset="0"/>
                  </a:rPr>
                  <a:t>start</a:t>
                </a:r>
                <a:endParaRPr lang="de-DE" sz="1200" b="1" u="sng" dirty="0">
                  <a:latin typeface="Palatino Linotype" panose="02040502050505030304" pitchFamily="18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Textfeld 5"/>
            <p:cNvSpPr txBox="1"/>
            <p:nvPr/>
          </p:nvSpPr>
          <p:spPr>
            <a:xfrm>
              <a:off x="8433261" y="5773351"/>
              <a:ext cx="640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adow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9580087" y="5368844"/>
              <a:ext cx="389337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</a:t>
              </a:r>
              <a:endParaRPr lang="de-DE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uppieren 47"/>
          <p:cNvGrpSpPr/>
          <p:nvPr/>
        </p:nvGrpSpPr>
        <p:grpSpPr>
          <a:xfrm>
            <a:off x="1063395" y="136376"/>
            <a:ext cx="10006617" cy="438150"/>
            <a:chOff x="1062021" y="330800"/>
            <a:chExt cx="10006617" cy="438150"/>
          </a:xfrm>
        </p:grpSpPr>
        <p:pic>
          <p:nvPicPr>
            <p:cNvPr id="52" name="Picture 3" descr="ijms_logo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Picture 1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0606418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5</Words>
  <Application>Microsoft Office PowerPoint</Application>
  <PresentationFormat>Breitbild</PresentationFormat>
  <Paragraphs>27</Paragraphs>
  <Slides>2</Slides>
  <Notes>0</Notes>
  <HiddenSlides>0</HiddenSlides>
  <MMClips>2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9" baseType="lpstr">
      <vt:lpstr>SimSun</vt:lpstr>
      <vt:lpstr>Arial</vt:lpstr>
      <vt:lpstr>Calibri</vt:lpstr>
      <vt:lpstr>DengXian</vt:lpstr>
      <vt:lpstr>Palatino Linotype</vt:lpstr>
      <vt:lpstr>Times New Roman</vt:lpstr>
      <vt:lpstr>Larissa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ansi, Felista</dc:creator>
  <cp:lastModifiedBy>Tansi, Felista L.</cp:lastModifiedBy>
  <cp:revision>98</cp:revision>
  <dcterms:created xsi:type="dcterms:W3CDTF">2021-01-26T10:31:05Z</dcterms:created>
  <dcterms:modified xsi:type="dcterms:W3CDTF">2024-05-21T07:44:25Z</dcterms:modified>
</cp:coreProperties>
</file>